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00" d="100"/>
          <a:sy n="100" d="100"/>
        </p:scale>
        <p:origin x="-2808" y="69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helgae\Documents\Artiklar\Pf%20transposonmutantar\PRO-MF-U47-2016_Pub_supplementary%20figure_02_12_2016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nb-NO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58642124194203"/>
          <c:y val="2.8114409280210417E-2"/>
          <c:w val="0.79411699544993797"/>
          <c:h val="0.75438733254921964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[PRO-MF-U47-2016_Pub_supplementary figure_02_12_2016.xlsx]Sheet1'!$K$1</c:f>
              <c:strCache>
                <c:ptCount val="1"/>
                <c:pt idx="0">
                  <c:v>PF SBW25 
(0 mM m-toluate)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x"/>
            <c:errBarType val="both"/>
            <c:errValType val="fixedVal"/>
            <c:noEndCap val="0"/>
            <c:val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y"/>
            <c:errBarType val="both"/>
            <c:errValType val="cust"/>
            <c:noEndCap val="0"/>
            <c:plus>
              <c:numRef>
                <c:f>'[PRO-MF-U47-2016_Pub_supplementary figure_02_12_2016.xlsx]Sheet1'!$O$2:$O$203</c:f>
                <c:numCache>
                  <c:formatCode>General</c:formatCode>
                  <c:ptCount val="202"/>
                  <c:pt idx="0">
                    <c:v>0</c:v>
                  </c:pt>
                  <c:pt idx="3">
                    <c:v>8.3432256230968026E-3</c:v>
                  </c:pt>
                  <c:pt idx="6">
                    <c:v>1.1874300849190214E-2</c:v>
                  </c:pt>
                  <c:pt idx="9">
                    <c:v>2.3796262102629792E-2</c:v>
                  </c:pt>
                  <c:pt idx="12">
                    <c:v>5.1027734353167993E-2</c:v>
                  </c:pt>
                  <c:pt idx="15">
                    <c:v>4.5425865812938081E-2</c:v>
                  </c:pt>
                  <c:pt idx="18">
                    <c:v>5.9138828309738822E-2</c:v>
                  </c:pt>
                  <c:pt idx="21">
                    <c:v>6.0943956293889781E-2</c:v>
                  </c:pt>
                  <c:pt idx="24">
                    <c:v>4.1789235246372083E-2</c:v>
                  </c:pt>
                  <c:pt idx="27">
                    <c:v>7.4009246287054853E-2</c:v>
                  </c:pt>
                  <c:pt idx="30">
                    <c:v>6.3528365226640918E-2</c:v>
                  </c:pt>
                  <c:pt idx="33">
                    <c:v>5.9018291165203962E-2</c:v>
                  </c:pt>
                  <c:pt idx="36">
                    <c:v>6.3408111693834104E-2</c:v>
                  </c:pt>
                  <c:pt idx="39">
                    <c:v>5.1727645754090182E-2</c:v>
                  </c:pt>
                  <c:pt idx="42">
                    <c:v>4.1720078448909625E-2</c:v>
                  </c:pt>
                  <c:pt idx="45">
                    <c:v>3.5126871065245889E-2</c:v>
                  </c:pt>
                  <c:pt idx="50">
                    <c:v>5.2703600640581993E-2</c:v>
                  </c:pt>
                  <c:pt idx="53">
                    <c:v>2.1614866915183512E-2</c:v>
                  </c:pt>
                  <c:pt idx="56">
                    <c:v>4.6593843245576423E-2</c:v>
                  </c:pt>
                  <c:pt idx="59">
                    <c:v>5.1346729451558153E-2</c:v>
                  </c:pt>
                  <c:pt idx="62">
                    <c:v>2.6795460670511671E-2</c:v>
                  </c:pt>
                  <c:pt idx="65">
                    <c:v>5.5215403113363849E-2</c:v>
                  </c:pt>
                  <c:pt idx="68">
                    <c:v>2.5762266574096481E-2</c:v>
                  </c:pt>
                  <c:pt idx="71">
                    <c:v>4.4454645091535738E-2</c:v>
                  </c:pt>
                  <c:pt idx="74">
                    <c:v>9.6658528540943575E-2</c:v>
                  </c:pt>
                  <c:pt idx="77">
                    <c:v>4.5054781805526238E-2</c:v>
                  </c:pt>
                  <c:pt idx="80">
                    <c:v>7.9240685094244173E-2</c:v>
                  </c:pt>
                  <c:pt idx="83">
                    <c:v>5.2395308089810064E-2</c:v>
                  </c:pt>
                  <c:pt idx="86">
                    <c:v>4.2520704683026649E-2</c:v>
                  </c:pt>
                  <c:pt idx="89">
                    <c:v>8.3737811881472626E-2</c:v>
                  </c:pt>
                  <c:pt idx="92">
                    <c:v>0.10903994068837314</c:v>
                  </c:pt>
                  <c:pt idx="95">
                    <c:v>8.232230730546336E-2</c:v>
                  </c:pt>
                  <c:pt idx="98">
                    <c:v>7.9256093563451521E-2</c:v>
                  </c:pt>
                  <c:pt idx="101">
                    <c:v>8.02494030604195E-2</c:v>
                  </c:pt>
                  <c:pt idx="104">
                    <c:v>9.3522766596294646E-2</c:v>
                  </c:pt>
                  <c:pt idx="107">
                    <c:v>0.10076355453399718</c:v>
                  </c:pt>
                  <c:pt idx="110">
                    <c:v>0.12351315605561705</c:v>
                  </c:pt>
                  <c:pt idx="113">
                    <c:v>8.6482152514269314E-2</c:v>
                  </c:pt>
                  <c:pt idx="116">
                    <c:v>0.10914657531882581</c:v>
                  </c:pt>
                  <c:pt idx="119">
                    <c:v>0.13988269760888891</c:v>
                  </c:pt>
                  <c:pt idx="124">
                    <c:v>0.12515762742040956</c:v>
                  </c:pt>
                  <c:pt idx="127">
                    <c:v>9.5623367566702935E-2</c:v>
                  </c:pt>
                  <c:pt idx="130">
                    <c:v>0.11424253001851999</c:v>
                  </c:pt>
                  <c:pt idx="133">
                    <c:v>0.10869293061669377</c:v>
                  </c:pt>
                  <c:pt idx="136">
                    <c:v>0.11163805000644045</c:v>
                  </c:pt>
                  <c:pt idx="139">
                    <c:v>0.13320573425059781</c:v>
                  </c:pt>
                  <c:pt idx="142">
                    <c:v>0.10871193516380977</c:v>
                  </c:pt>
                  <c:pt idx="147">
                    <c:v>0.12568489376115038</c:v>
                  </c:pt>
                  <c:pt idx="150">
                    <c:v>0.11742655855730109</c:v>
                  </c:pt>
                  <c:pt idx="153">
                    <c:v>0.13141408234234631</c:v>
                  </c:pt>
                  <c:pt idx="156">
                    <c:v>0.14692284486768944</c:v>
                  </c:pt>
                  <c:pt idx="159">
                    <c:v>0.1227996580421146</c:v>
                  </c:pt>
                  <c:pt idx="162">
                    <c:v>0.10996209854635429</c:v>
                  </c:pt>
                  <c:pt idx="165">
                    <c:v>9.4936109347415448E-2</c:v>
                  </c:pt>
                  <c:pt idx="168">
                    <c:v>9.7046624542882473E-2</c:v>
                  </c:pt>
                  <c:pt idx="171">
                    <c:v>0.14296935180631659</c:v>
                  </c:pt>
                  <c:pt idx="174">
                    <c:v>0.14090228254444281</c:v>
                  </c:pt>
                  <c:pt idx="177">
                    <c:v>0.12892150418615139</c:v>
                  </c:pt>
                  <c:pt idx="180">
                    <c:v>0.11157170494625307</c:v>
                  </c:pt>
                  <c:pt idx="183">
                    <c:v>9.2360720832325396E-2</c:v>
                  </c:pt>
                  <c:pt idx="186">
                    <c:v>0.10745977972904644</c:v>
                  </c:pt>
                  <c:pt idx="189">
                    <c:v>9.4758223763732621E-2</c:v>
                  </c:pt>
                  <c:pt idx="192">
                    <c:v>8.4330882417662761E-2</c:v>
                  </c:pt>
                  <c:pt idx="195">
                    <c:v>9.5901590272477993E-2</c:v>
                  </c:pt>
                  <c:pt idx="198">
                    <c:v>0.11526631226236299</c:v>
                  </c:pt>
                  <c:pt idx="201">
                    <c:v>9.5932995153325054E-2</c:v>
                  </c:pt>
                </c:numCache>
              </c:numRef>
            </c:plus>
            <c:minus>
              <c:numRef>
                <c:f>'[PRO-MF-U47-2016_Pub_supplementary figure_02_12_2016.xlsx]Sheet1'!$O$2:$O$203</c:f>
                <c:numCache>
                  <c:formatCode>General</c:formatCode>
                  <c:ptCount val="202"/>
                  <c:pt idx="0">
                    <c:v>0</c:v>
                  </c:pt>
                  <c:pt idx="3">
                    <c:v>8.3432256230968026E-3</c:v>
                  </c:pt>
                  <c:pt idx="6">
                    <c:v>1.1874300849190214E-2</c:v>
                  </c:pt>
                  <c:pt idx="9">
                    <c:v>2.3796262102629792E-2</c:v>
                  </c:pt>
                  <c:pt idx="12">
                    <c:v>5.1027734353167993E-2</c:v>
                  </c:pt>
                  <c:pt idx="15">
                    <c:v>4.5425865812938081E-2</c:v>
                  </c:pt>
                  <c:pt idx="18">
                    <c:v>5.9138828309738822E-2</c:v>
                  </c:pt>
                  <c:pt idx="21">
                    <c:v>6.0943956293889781E-2</c:v>
                  </c:pt>
                  <c:pt idx="24">
                    <c:v>4.1789235246372083E-2</c:v>
                  </c:pt>
                  <c:pt idx="27">
                    <c:v>7.4009246287054853E-2</c:v>
                  </c:pt>
                  <c:pt idx="30">
                    <c:v>6.3528365226640918E-2</c:v>
                  </c:pt>
                  <c:pt idx="33">
                    <c:v>5.9018291165203962E-2</c:v>
                  </c:pt>
                  <c:pt idx="36">
                    <c:v>6.3408111693834104E-2</c:v>
                  </c:pt>
                  <c:pt idx="39">
                    <c:v>5.1727645754090182E-2</c:v>
                  </c:pt>
                  <c:pt idx="42">
                    <c:v>4.1720078448909625E-2</c:v>
                  </c:pt>
                  <c:pt idx="45">
                    <c:v>3.5126871065245889E-2</c:v>
                  </c:pt>
                  <c:pt idx="50">
                    <c:v>5.2703600640581993E-2</c:v>
                  </c:pt>
                  <c:pt idx="53">
                    <c:v>2.1614866915183512E-2</c:v>
                  </c:pt>
                  <c:pt idx="56">
                    <c:v>4.6593843245576423E-2</c:v>
                  </c:pt>
                  <c:pt idx="59">
                    <c:v>5.1346729451558153E-2</c:v>
                  </c:pt>
                  <c:pt idx="62">
                    <c:v>2.6795460670511671E-2</c:v>
                  </c:pt>
                  <c:pt idx="65">
                    <c:v>5.5215403113363849E-2</c:v>
                  </c:pt>
                  <c:pt idx="68">
                    <c:v>2.5762266574096481E-2</c:v>
                  </c:pt>
                  <c:pt idx="71">
                    <c:v>4.4454645091535738E-2</c:v>
                  </c:pt>
                  <c:pt idx="74">
                    <c:v>9.6658528540943575E-2</c:v>
                  </c:pt>
                  <c:pt idx="77">
                    <c:v>4.5054781805526238E-2</c:v>
                  </c:pt>
                  <c:pt idx="80">
                    <c:v>7.9240685094244173E-2</c:v>
                  </c:pt>
                  <c:pt idx="83">
                    <c:v>5.2395308089810064E-2</c:v>
                  </c:pt>
                  <c:pt idx="86">
                    <c:v>4.2520704683026649E-2</c:v>
                  </c:pt>
                  <c:pt idx="89">
                    <c:v>8.3737811881472626E-2</c:v>
                  </c:pt>
                  <c:pt idx="92">
                    <c:v>0.10903994068837314</c:v>
                  </c:pt>
                  <c:pt idx="95">
                    <c:v>8.232230730546336E-2</c:v>
                  </c:pt>
                  <c:pt idx="98">
                    <c:v>7.9256093563451521E-2</c:v>
                  </c:pt>
                  <c:pt idx="101">
                    <c:v>8.02494030604195E-2</c:v>
                  </c:pt>
                  <c:pt idx="104">
                    <c:v>9.3522766596294646E-2</c:v>
                  </c:pt>
                  <c:pt idx="107">
                    <c:v>0.10076355453399718</c:v>
                  </c:pt>
                  <c:pt idx="110">
                    <c:v>0.12351315605561705</c:v>
                  </c:pt>
                  <c:pt idx="113">
                    <c:v>8.6482152514269314E-2</c:v>
                  </c:pt>
                  <c:pt idx="116">
                    <c:v>0.10914657531882581</c:v>
                  </c:pt>
                  <c:pt idx="119">
                    <c:v>0.13988269760888891</c:v>
                  </c:pt>
                  <c:pt idx="124">
                    <c:v>0.12515762742040956</c:v>
                  </c:pt>
                  <c:pt idx="127">
                    <c:v>9.5623367566702935E-2</c:v>
                  </c:pt>
                  <c:pt idx="130">
                    <c:v>0.11424253001851999</c:v>
                  </c:pt>
                  <c:pt idx="133">
                    <c:v>0.10869293061669377</c:v>
                  </c:pt>
                  <c:pt idx="136">
                    <c:v>0.11163805000644045</c:v>
                  </c:pt>
                  <c:pt idx="139">
                    <c:v>0.13320573425059781</c:v>
                  </c:pt>
                  <c:pt idx="142">
                    <c:v>0.10871193516380977</c:v>
                  </c:pt>
                  <c:pt idx="147">
                    <c:v>0.12568489376115038</c:v>
                  </c:pt>
                  <c:pt idx="150">
                    <c:v>0.11742655855730109</c:v>
                  </c:pt>
                  <c:pt idx="153">
                    <c:v>0.13141408234234631</c:v>
                  </c:pt>
                  <c:pt idx="156">
                    <c:v>0.14692284486768944</c:v>
                  </c:pt>
                  <c:pt idx="159">
                    <c:v>0.1227996580421146</c:v>
                  </c:pt>
                  <c:pt idx="162">
                    <c:v>0.10996209854635429</c:v>
                  </c:pt>
                  <c:pt idx="165">
                    <c:v>9.4936109347415448E-2</c:v>
                  </c:pt>
                  <c:pt idx="168">
                    <c:v>9.7046624542882473E-2</c:v>
                  </c:pt>
                  <c:pt idx="171">
                    <c:v>0.14296935180631659</c:v>
                  </c:pt>
                  <c:pt idx="174">
                    <c:v>0.14090228254444281</c:v>
                  </c:pt>
                  <c:pt idx="177">
                    <c:v>0.12892150418615139</c:v>
                  </c:pt>
                  <c:pt idx="180">
                    <c:v>0.11157170494625307</c:v>
                  </c:pt>
                  <c:pt idx="183">
                    <c:v>9.2360720832325396E-2</c:v>
                  </c:pt>
                  <c:pt idx="186">
                    <c:v>0.10745977972904644</c:v>
                  </c:pt>
                  <c:pt idx="189">
                    <c:v>9.4758223763732621E-2</c:v>
                  </c:pt>
                  <c:pt idx="192">
                    <c:v>8.4330882417662761E-2</c:v>
                  </c:pt>
                  <c:pt idx="195">
                    <c:v>9.5901590272477993E-2</c:v>
                  </c:pt>
                  <c:pt idx="198">
                    <c:v>0.11526631226236299</c:v>
                  </c:pt>
                  <c:pt idx="201">
                    <c:v>9.593299515332505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2">
                    <a:lumMod val="60000"/>
                    <a:lumOff val="40000"/>
                  </a:schemeClr>
                </a:solidFill>
                <a:round/>
              </a:ln>
              <a:effectLst/>
            </c:spPr>
          </c:errBars>
          <c:xVal>
            <c:numRef>
              <c:f>'[PRO-MF-U47-2016_Pub_supplementary figure_02_12_2016.xlsx]Sheet1'!$J$2:$J$203</c:f>
              <c:numCache>
                <c:formatCode>General</c:formatCode>
                <c:ptCount val="202"/>
                <c:pt idx="0">
                  <c:v>3.0009999999999998E-2</c:v>
                </c:pt>
                <c:pt idx="1">
                  <c:v>0.34233999999999998</c:v>
                </c:pt>
                <c:pt idx="2">
                  <c:v>0.67566999999999999</c:v>
                </c:pt>
                <c:pt idx="3">
                  <c:v>1.00908</c:v>
                </c:pt>
                <c:pt idx="4">
                  <c:v>1.3426</c:v>
                </c:pt>
                <c:pt idx="5">
                  <c:v>1.6755899999999999</c:v>
                </c:pt>
                <c:pt idx="6">
                  <c:v>2.0094099999999999</c:v>
                </c:pt>
                <c:pt idx="7">
                  <c:v>2.3427500000000001</c:v>
                </c:pt>
                <c:pt idx="8">
                  <c:v>2.6759599999999999</c:v>
                </c:pt>
                <c:pt idx="9">
                  <c:v>3.0095000000000001</c:v>
                </c:pt>
                <c:pt idx="10">
                  <c:v>3.3424900000000002</c:v>
                </c:pt>
                <c:pt idx="11">
                  <c:v>3.6761300000000001</c:v>
                </c:pt>
                <c:pt idx="12">
                  <c:v>4.0097500000000004</c:v>
                </c:pt>
                <c:pt idx="13">
                  <c:v>4.3426799999999997</c:v>
                </c:pt>
                <c:pt idx="14">
                  <c:v>4.6763000000000003</c:v>
                </c:pt>
                <c:pt idx="15">
                  <c:v>5.0099099999999996</c:v>
                </c:pt>
                <c:pt idx="16">
                  <c:v>5.343</c:v>
                </c:pt>
                <c:pt idx="17">
                  <c:v>5.6763000000000003</c:v>
                </c:pt>
                <c:pt idx="18">
                  <c:v>6.0100800000000003</c:v>
                </c:pt>
                <c:pt idx="19">
                  <c:v>6.3433999999999999</c:v>
                </c:pt>
                <c:pt idx="20">
                  <c:v>6.6766399999999999</c:v>
                </c:pt>
                <c:pt idx="21">
                  <c:v>7.0101199999999997</c:v>
                </c:pt>
                <c:pt idx="22">
                  <c:v>7.3433799999999998</c:v>
                </c:pt>
                <c:pt idx="23">
                  <c:v>7.6769699999999998</c:v>
                </c:pt>
                <c:pt idx="24">
                  <c:v>8.0101800000000001</c:v>
                </c:pt>
                <c:pt idx="25">
                  <c:v>8.34361</c:v>
                </c:pt>
                <c:pt idx="26">
                  <c:v>8.6769300000000005</c:v>
                </c:pt>
                <c:pt idx="27">
                  <c:v>9.0103299999999997</c:v>
                </c:pt>
                <c:pt idx="28">
                  <c:v>9.34389</c:v>
                </c:pt>
                <c:pt idx="29">
                  <c:v>9.6772299999999998</c:v>
                </c:pt>
                <c:pt idx="30">
                  <c:v>10.010479999999999</c:v>
                </c:pt>
                <c:pt idx="31">
                  <c:v>10.343920000000001</c:v>
                </c:pt>
                <c:pt idx="32">
                  <c:v>10.67733</c:v>
                </c:pt>
                <c:pt idx="33">
                  <c:v>11.01094</c:v>
                </c:pt>
                <c:pt idx="34">
                  <c:v>11.34399</c:v>
                </c:pt>
                <c:pt idx="35">
                  <c:v>11.67736</c:v>
                </c:pt>
                <c:pt idx="36">
                  <c:v>12.01094</c:v>
                </c:pt>
                <c:pt idx="37">
                  <c:v>12.34432</c:v>
                </c:pt>
                <c:pt idx="38">
                  <c:v>12.67742</c:v>
                </c:pt>
                <c:pt idx="39">
                  <c:v>13.011240000000001</c:v>
                </c:pt>
                <c:pt idx="40">
                  <c:v>13.34459</c:v>
                </c:pt>
                <c:pt idx="41">
                  <c:v>13.67789</c:v>
                </c:pt>
                <c:pt idx="42">
                  <c:v>14.011279999999999</c:v>
                </c:pt>
                <c:pt idx="43">
                  <c:v>14.34464</c:v>
                </c:pt>
                <c:pt idx="44">
                  <c:v>14.67784</c:v>
                </c:pt>
                <c:pt idx="45">
                  <c:v>15.011520000000001</c:v>
                </c:pt>
                <c:pt idx="46">
                  <c:v>15.344749999999999</c:v>
                </c:pt>
                <c:pt idx="47">
                  <c:v>15.67792</c:v>
                </c:pt>
                <c:pt idx="48">
                  <c:v>16.01155</c:v>
                </c:pt>
                <c:pt idx="49">
                  <c:v>16.344909999999999</c:v>
                </c:pt>
                <c:pt idx="50">
                  <c:v>16.678129999999999</c:v>
                </c:pt>
                <c:pt idx="51">
                  <c:v>17.011659999999999</c:v>
                </c:pt>
                <c:pt idx="52">
                  <c:v>17.345099999999999</c:v>
                </c:pt>
                <c:pt idx="53">
                  <c:v>17.678450000000002</c:v>
                </c:pt>
                <c:pt idx="54">
                  <c:v>18.011620000000001</c:v>
                </c:pt>
                <c:pt idx="55">
                  <c:v>18.345120000000001</c:v>
                </c:pt>
                <c:pt idx="56">
                  <c:v>18.678319999999999</c:v>
                </c:pt>
                <c:pt idx="57">
                  <c:v>19.011880000000001</c:v>
                </c:pt>
                <c:pt idx="58">
                  <c:v>19.345469999999999</c:v>
                </c:pt>
                <c:pt idx="59">
                  <c:v>19.678719999999998</c:v>
                </c:pt>
                <c:pt idx="60">
                  <c:v>20.012049999999999</c:v>
                </c:pt>
                <c:pt idx="61">
                  <c:v>20.345369999999999</c:v>
                </c:pt>
                <c:pt idx="62">
                  <c:v>20.679079999999999</c:v>
                </c:pt>
                <c:pt idx="63">
                  <c:v>21.012309999999999</c:v>
                </c:pt>
                <c:pt idx="64">
                  <c:v>21.34571</c:v>
                </c:pt>
                <c:pt idx="65">
                  <c:v>21.679010000000002</c:v>
                </c:pt>
                <c:pt idx="66">
                  <c:v>22.012460000000001</c:v>
                </c:pt>
                <c:pt idx="67">
                  <c:v>22.346039999999999</c:v>
                </c:pt>
                <c:pt idx="68">
                  <c:v>22.679400000000001</c:v>
                </c:pt>
                <c:pt idx="69">
                  <c:v>23.012409999999999</c:v>
                </c:pt>
                <c:pt idx="70">
                  <c:v>23.34581</c:v>
                </c:pt>
                <c:pt idx="71">
                  <c:v>23.679580000000001</c:v>
                </c:pt>
                <c:pt idx="72">
                  <c:v>24.01285</c:v>
                </c:pt>
                <c:pt idx="73">
                  <c:v>24.345890000000001</c:v>
                </c:pt>
                <c:pt idx="74">
                  <c:v>24.679559999999999</c:v>
                </c:pt>
                <c:pt idx="75">
                  <c:v>25.012879999999999</c:v>
                </c:pt>
                <c:pt idx="76">
                  <c:v>25.346219999999999</c:v>
                </c:pt>
                <c:pt idx="77">
                  <c:v>25.67944</c:v>
                </c:pt>
                <c:pt idx="78">
                  <c:v>26.013069999999999</c:v>
                </c:pt>
                <c:pt idx="79">
                  <c:v>26.346309999999999</c:v>
                </c:pt>
                <c:pt idx="80">
                  <c:v>26.679849999999998</c:v>
                </c:pt>
                <c:pt idx="81">
                  <c:v>27.01305</c:v>
                </c:pt>
                <c:pt idx="82">
                  <c:v>27.346240000000002</c:v>
                </c:pt>
                <c:pt idx="83">
                  <c:v>27.68019</c:v>
                </c:pt>
                <c:pt idx="84">
                  <c:v>28.013439999999999</c:v>
                </c:pt>
                <c:pt idx="85">
                  <c:v>28.346509999999999</c:v>
                </c:pt>
                <c:pt idx="86">
                  <c:v>28.680299999999999</c:v>
                </c:pt>
                <c:pt idx="87">
                  <c:v>29.013539999999999</c:v>
                </c:pt>
                <c:pt idx="88">
                  <c:v>29.346979999999999</c:v>
                </c:pt>
                <c:pt idx="89">
                  <c:v>29.680009999999999</c:v>
                </c:pt>
                <c:pt idx="90">
                  <c:v>30.013639999999999</c:v>
                </c:pt>
                <c:pt idx="91">
                  <c:v>30.347190000000001</c:v>
                </c:pt>
                <c:pt idx="92">
                  <c:v>30.680430000000001</c:v>
                </c:pt>
                <c:pt idx="93">
                  <c:v>31.013839999999998</c:v>
                </c:pt>
                <c:pt idx="94">
                  <c:v>31.347169999999998</c:v>
                </c:pt>
                <c:pt idx="95">
                  <c:v>31.680219999999998</c:v>
                </c:pt>
                <c:pt idx="96">
                  <c:v>32.014060000000001</c:v>
                </c:pt>
                <c:pt idx="97">
                  <c:v>32.347529999999999</c:v>
                </c:pt>
                <c:pt idx="98">
                  <c:v>32.680729999999997</c:v>
                </c:pt>
                <c:pt idx="99">
                  <c:v>33.014209999999999</c:v>
                </c:pt>
                <c:pt idx="100">
                  <c:v>33.34742</c:v>
                </c:pt>
                <c:pt idx="101">
                  <c:v>33.681249999999999</c:v>
                </c:pt>
                <c:pt idx="102">
                  <c:v>34.014339999999997</c:v>
                </c:pt>
                <c:pt idx="103">
                  <c:v>34.34769</c:v>
                </c:pt>
                <c:pt idx="104">
                  <c:v>34.681199999999997</c:v>
                </c:pt>
                <c:pt idx="105">
                  <c:v>35.01464</c:v>
                </c:pt>
                <c:pt idx="106">
                  <c:v>35.348030000000001</c:v>
                </c:pt>
                <c:pt idx="107">
                  <c:v>35.681199999999997</c:v>
                </c:pt>
                <c:pt idx="108">
                  <c:v>36.014530000000001</c:v>
                </c:pt>
                <c:pt idx="109">
                  <c:v>36.348089999999999</c:v>
                </c:pt>
                <c:pt idx="110">
                  <c:v>36.681359999999998</c:v>
                </c:pt>
                <c:pt idx="111">
                  <c:v>37.014690000000002</c:v>
                </c:pt>
                <c:pt idx="112">
                  <c:v>37.347969999999997</c:v>
                </c:pt>
                <c:pt idx="113">
                  <c:v>37.681730000000002</c:v>
                </c:pt>
                <c:pt idx="114">
                  <c:v>38.014949999999999</c:v>
                </c:pt>
                <c:pt idx="115">
                  <c:v>38.348399999999998</c:v>
                </c:pt>
                <c:pt idx="116">
                  <c:v>38.682000000000002</c:v>
                </c:pt>
                <c:pt idx="117">
                  <c:v>39.015169999999998</c:v>
                </c:pt>
                <c:pt idx="118">
                  <c:v>39.348559999999999</c:v>
                </c:pt>
                <c:pt idx="119">
                  <c:v>39.682020000000001</c:v>
                </c:pt>
                <c:pt idx="120">
                  <c:v>40.015349999999998</c:v>
                </c:pt>
                <c:pt idx="121">
                  <c:v>40.348689999999998</c:v>
                </c:pt>
                <c:pt idx="122">
                  <c:v>40.682250000000003</c:v>
                </c:pt>
                <c:pt idx="123">
                  <c:v>41.015340000000002</c:v>
                </c:pt>
                <c:pt idx="124">
                  <c:v>41.349110000000003</c:v>
                </c:pt>
                <c:pt idx="125">
                  <c:v>41.68233</c:v>
                </c:pt>
                <c:pt idx="126">
                  <c:v>42.015639999999998</c:v>
                </c:pt>
                <c:pt idx="127">
                  <c:v>42.348820000000003</c:v>
                </c:pt>
                <c:pt idx="128">
                  <c:v>42.68244</c:v>
                </c:pt>
                <c:pt idx="129">
                  <c:v>43.015770000000003</c:v>
                </c:pt>
                <c:pt idx="130">
                  <c:v>43.349319999999999</c:v>
                </c:pt>
                <c:pt idx="131">
                  <c:v>43.682429999999997</c:v>
                </c:pt>
                <c:pt idx="132">
                  <c:v>44.015700000000002</c:v>
                </c:pt>
                <c:pt idx="133">
                  <c:v>44.349409999999999</c:v>
                </c:pt>
                <c:pt idx="134">
                  <c:v>44.682740000000003</c:v>
                </c:pt>
                <c:pt idx="135">
                  <c:v>45.015929999999997</c:v>
                </c:pt>
                <c:pt idx="136">
                  <c:v>45.349499999999999</c:v>
                </c:pt>
                <c:pt idx="137">
                  <c:v>45.683019999999999</c:v>
                </c:pt>
                <c:pt idx="138">
                  <c:v>46.01632</c:v>
                </c:pt>
                <c:pt idx="139">
                  <c:v>46.349629999999998</c:v>
                </c:pt>
                <c:pt idx="140">
                  <c:v>46.683239999999998</c:v>
                </c:pt>
                <c:pt idx="141">
                  <c:v>47.016240000000003</c:v>
                </c:pt>
                <c:pt idx="142">
                  <c:v>47.349719999999998</c:v>
                </c:pt>
                <c:pt idx="143">
                  <c:v>47.683349999999997</c:v>
                </c:pt>
                <c:pt idx="144">
                  <c:v>48.016629999999999</c:v>
                </c:pt>
                <c:pt idx="145">
                  <c:v>48.349679999999999</c:v>
                </c:pt>
                <c:pt idx="146">
                  <c:v>48.683540000000001</c:v>
                </c:pt>
                <c:pt idx="147">
                  <c:v>49.016579999999998</c:v>
                </c:pt>
                <c:pt idx="148">
                  <c:v>49.35022</c:v>
                </c:pt>
                <c:pt idx="149">
                  <c:v>49.683419999999998</c:v>
                </c:pt>
                <c:pt idx="150">
                  <c:v>50.016750000000002</c:v>
                </c:pt>
                <c:pt idx="151">
                  <c:v>50.35051</c:v>
                </c:pt>
                <c:pt idx="152">
                  <c:v>50.683419999999998</c:v>
                </c:pt>
                <c:pt idx="153">
                  <c:v>51.017330000000001</c:v>
                </c:pt>
                <c:pt idx="154">
                  <c:v>51.350200000000001</c:v>
                </c:pt>
                <c:pt idx="155">
                  <c:v>51.684019999999997</c:v>
                </c:pt>
                <c:pt idx="156">
                  <c:v>52.01708</c:v>
                </c:pt>
                <c:pt idx="157">
                  <c:v>52.350490000000001</c:v>
                </c:pt>
                <c:pt idx="158">
                  <c:v>52.684010000000001</c:v>
                </c:pt>
                <c:pt idx="159">
                  <c:v>53.01726</c:v>
                </c:pt>
                <c:pt idx="160">
                  <c:v>53.35078</c:v>
                </c:pt>
                <c:pt idx="161">
                  <c:v>53.684379999999997</c:v>
                </c:pt>
                <c:pt idx="162">
                  <c:v>54.017249999999997</c:v>
                </c:pt>
                <c:pt idx="163">
                  <c:v>54.350920000000002</c:v>
                </c:pt>
                <c:pt idx="164">
                  <c:v>54.684269999999998</c:v>
                </c:pt>
                <c:pt idx="165">
                  <c:v>55.017539999999997</c:v>
                </c:pt>
                <c:pt idx="166">
                  <c:v>55.350729999999999</c:v>
                </c:pt>
                <c:pt idx="167">
                  <c:v>55.684429999999999</c:v>
                </c:pt>
                <c:pt idx="168">
                  <c:v>56.017679999999999</c:v>
                </c:pt>
                <c:pt idx="169">
                  <c:v>56.35125</c:v>
                </c:pt>
                <c:pt idx="170">
                  <c:v>56.684759999999997</c:v>
                </c:pt>
                <c:pt idx="171">
                  <c:v>57.018050000000002</c:v>
                </c:pt>
                <c:pt idx="172">
                  <c:v>57.351529999999997</c:v>
                </c:pt>
                <c:pt idx="173">
                  <c:v>57.684820000000002</c:v>
                </c:pt>
                <c:pt idx="174">
                  <c:v>58.018140000000002</c:v>
                </c:pt>
                <c:pt idx="175">
                  <c:v>58.351640000000003</c:v>
                </c:pt>
                <c:pt idx="176">
                  <c:v>58.684710000000003</c:v>
                </c:pt>
                <c:pt idx="177">
                  <c:v>59.018340000000002</c:v>
                </c:pt>
                <c:pt idx="178">
                  <c:v>59.351489999999998</c:v>
                </c:pt>
                <c:pt idx="179">
                  <c:v>59.685099999999998</c:v>
                </c:pt>
                <c:pt idx="180">
                  <c:v>60.018729999999998</c:v>
                </c:pt>
                <c:pt idx="181">
                  <c:v>60.35192</c:v>
                </c:pt>
                <c:pt idx="182">
                  <c:v>60.685189999999999</c:v>
                </c:pt>
                <c:pt idx="183">
                  <c:v>61.018700000000003</c:v>
                </c:pt>
                <c:pt idx="184">
                  <c:v>61.352220000000003</c:v>
                </c:pt>
                <c:pt idx="185">
                  <c:v>61.685470000000002</c:v>
                </c:pt>
                <c:pt idx="186">
                  <c:v>62.018439999999998</c:v>
                </c:pt>
                <c:pt idx="187">
                  <c:v>62.352249999999998</c:v>
                </c:pt>
                <c:pt idx="188">
                  <c:v>62.685589999999998</c:v>
                </c:pt>
                <c:pt idx="189">
                  <c:v>63.018949999999997</c:v>
                </c:pt>
                <c:pt idx="190">
                  <c:v>63.3523</c:v>
                </c:pt>
                <c:pt idx="191">
                  <c:v>63.685650000000003</c:v>
                </c:pt>
                <c:pt idx="192">
                  <c:v>64.019620000000003</c:v>
                </c:pt>
                <c:pt idx="193">
                  <c:v>64.352329999999995</c:v>
                </c:pt>
                <c:pt idx="194">
                  <c:v>64.685869999999994</c:v>
                </c:pt>
                <c:pt idx="195">
                  <c:v>65.019199999999998</c:v>
                </c:pt>
                <c:pt idx="196">
                  <c:v>65.352400000000003</c:v>
                </c:pt>
                <c:pt idx="197">
                  <c:v>65.685969999999998</c:v>
                </c:pt>
                <c:pt idx="198">
                  <c:v>66.019649999999999</c:v>
                </c:pt>
                <c:pt idx="199">
                  <c:v>66.352630000000005</c:v>
                </c:pt>
                <c:pt idx="200">
                  <c:v>66.685950000000005</c:v>
                </c:pt>
                <c:pt idx="201">
                  <c:v>67.019549999999995</c:v>
                </c:pt>
              </c:numCache>
            </c:numRef>
          </c:xVal>
          <c:yVal>
            <c:numRef>
              <c:f>'[PRO-MF-U47-2016_Pub_supplementary figure_02_12_2016.xlsx]Sheet1'!$K$2:$K$203</c:f>
              <c:numCache>
                <c:formatCode>General</c:formatCode>
                <c:ptCount val="202"/>
                <c:pt idx="0">
                  <c:v>5.0000000000000044E-2</c:v>
                </c:pt>
                <c:pt idx="3">
                  <c:v>0.15655258961221916</c:v>
                </c:pt>
                <c:pt idx="6">
                  <c:v>0.11123427170287989</c:v>
                </c:pt>
                <c:pt idx="9">
                  <c:v>0.35209067752541234</c:v>
                </c:pt>
                <c:pt idx="12">
                  <c:v>0.68818862496277111</c:v>
                </c:pt>
                <c:pt idx="15">
                  <c:v>0.97187541132831301</c:v>
                </c:pt>
                <c:pt idx="18">
                  <c:v>1.2725437046659587</c:v>
                </c:pt>
                <c:pt idx="21">
                  <c:v>1.5180830216730525</c:v>
                </c:pt>
                <c:pt idx="24">
                  <c:v>1.6623532219838189</c:v>
                </c:pt>
                <c:pt idx="27">
                  <c:v>1.6905520990300724</c:v>
                </c:pt>
                <c:pt idx="30">
                  <c:v>1.7593928236380509</c:v>
                </c:pt>
                <c:pt idx="33">
                  <c:v>1.8603072770181051</c:v>
                </c:pt>
                <c:pt idx="36">
                  <c:v>1.9742361779644466</c:v>
                </c:pt>
                <c:pt idx="39">
                  <c:v>1.985242733989711</c:v>
                </c:pt>
                <c:pt idx="42">
                  <c:v>2.0310541954370778</c:v>
                </c:pt>
                <c:pt idx="45">
                  <c:v>2.0972692571263321</c:v>
                </c:pt>
                <c:pt idx="50">
                  <c:v>2.1407266246775323</c:v>
                </c:pt>
                <c:pt idx="53">
                  <c:v>2.1755406330144629</c:v>
                </c:pt>
                <c:pt idx="56">
                  <c:v>2.1637905837591815</c:v>
                </c:pt>
                <c:pt idx="59">
                  <c:v>2.2064893393394271</c:v>
                </c:pt>
                <c:pt idx="62">
                  <c:v>2.2477185934653074</c:v>
                </c:pt>
                <c:pt idx="65">
                  <c:v>2.2395746624810688</c:v>
                </c:pt>
                <c:pt idx="68">
                  <c:v>2.2753480416540093</c:v>
                </c:pt>
                <c:pt idx="71">
                  <c:v>2.3025953074011678</c:v>
                </c:pt>
                <c:pt idx="74">
                  <c:v>2.372609407961082</c:v>
                </c:pt>
                <c:pt idx="77">
                  <c:v>2.3669177886464761</c:v>
                </c:pt>
                <c:pt idx="80">
                  <c:v>2.3990631325389713</c:v>
                </c:pt>
                <c:pt idx="83">
                  <c:v>2.4061474004733578</c:v>
                </c:pt>
                <c:pt idx="86">
                  <c:v>2.4165543881086426</c:v>
                </c:pt>
                <c:pt idx="89">
                  <c:v>2.4435527278321794</c:v>
                </c:pt>
                <c:pt idx="92">
                  <c:v>2.4742194647322946</c:v>
                </c:pt>
                <c:pt idx="95">
                  <c:v>2.491068461695618</c:v>
                </c:pt>
                <c:pt idx="98">
                  <c:v>2.4908153529965604</c:v>
                </c:pt>
                <c:pt idx="101">
                  <c:v>2.5721288356600294</c:v>
                </c:pt>
                <c:pt idx="104">
                  <c:v>2.5469060534938217</c:v>
                </c:pt>
                <c:pt idx="107">
                  <c:v>2.5630091838656117</c:v>
                </c:pt>
                <c:pt idx="110">
                  <c:v>2.5910110123091696</c:v>
                </c:pt>
                <c:pt idx="113">
                  <c:v>2.5992340998199639</c:v>
                </c:pt>
                <c:pt idx="116">
                  <c:v>2.5601715022715177</c:v>
                </c:pt>
                <c:pt idx="119">
                  <c:v>2.6037982003207407</c:v>
                </c:pt>
                <c:pt idx="124">
                  <c:v>2.61825070910451</c:v>
                </c:pt>
                <c:pt idx="127">
                  <c:v>2.6049851531525059</c:v>
                </c:pt>
                <c:pt idx="130">
                  <c:v>2.6569050122335383</c:v>
                </c:pt>
                <c:pt idx="133">
                  <c:v>2.6398078317172278</c:v>
                </c:pt>
                <c:pt idx="136">
                  <c:v>2.6631188812002722</c:v>
                </c:pt>
                <c:pt idx="139">
                  <c:v>2.6057160467801315</c:v>
                </c:pt>
                <c:pt idx="142">
                  <c:v>2.6552292941002467</c:v>
                </c:pt>
                <c:pt idx="147">
                  <c:v>2.6601948729845337</c:v>
                </c:pt>
                <c:pt idx="150">
                  <c:v>2.6388500002840654</c:v>
                </c:pt>
                <c:pt idx="153">
                  <c:v>2.6840162477940228</c:v>
                </c:pt>
                <c:pt idx="156">
                  <c:v>2.6825178002761416</c:v>
                </c:pt>
                <c:pt idx="159">
                  <c:v>2.7181854722464371</c:v>
                </c:pt>
                <c:pt idx="162">
                  <c:v>2.7161361650279146</c:v>
                </c:pt>
                <c:pt idx="165">
                  <c:v>2.6917447029548969</c:v>
                </c:pt>
                <c:pt idx="168">
                  <c:v>2.7445198732377629</c:v>
                </c:pt>
                <c:pt idx="171">
                  <c:v>2.7223366320010953</c:v>
                </c:pt>
                <c:pt idx="174">
                  <c:v>2.7391393791875536</c:v>
                </c:pt>
                <c:pt idx="177">
                  <c:v>2.7552296207103049</c:v>
                </c:pt>
                <c:pt idx="180">
                  <c:v>2.7420819150416884</c:v>
                </c:pt>
                <c:pt idx="183">
                  <c:v>2.7565359694420755</c:v>
                </c:pt>
                <c:pt idx="186">
                  <c:v>2.7346919638553224</c:v>
                </c:pt>
                <c:pt idx="189">
                  <c:v>2.7441486659653425</c:v>
                </c:pt>
                <c:pt idx="192">
                  <c:v>2.7518317985551461</c:v>
                </c:pt>
                <c:pt idx="195">
                  <c:v>2.7421255694216309</c:v>
                </c:pt>
                <c:pt idx="198">
                  <c:v>2.7791938918993453</c:v>
                </c:pt>
                <c:pt idx="201">
                  <c:v>2.7388163344893059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'[PRO-MF-U47-2016_Pub_supplementary figure_02_12_2016.xlsx]Sheet1'!$L$1</c:f>
              <c:strCache>
                <c:ptCount val="1"/>
                <c:pt idx="0">
                  <c:v>PF SBW25 
(0.5 mM m-toluate)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x"/>
            <c:errBarType val="both"/>
            <c:errValType val="fixedVal"/>
            <c:noEndCap val="0"/>
            <c:val val="0"/>
            <c:spPr>
              <a:noFill/>
              <a:ln w="9525" cap="flat" cmpd="sng" algn="ctr">
                <a:solidFill>
                  <a:srgbClr val="FFC000"/>
                </a:solidFill>
                <a:round/>
              </a:ln>
              <a:effectLst/>
            </c:spPr>
          </c:errBars>
          <c:errBars>
            <c:errDir val="y"/>
            <c:errBarType val="both"/>
            <c:errValType val="cust"/>
            <c:noEndCap val="0"/>
            <c:plus>
              <c:numRef>
                <c:f>'[PRO-MF-U47-2016_Pub_supplementary figure_02_12_2016.xlsx]Sheet1'!$P$2:$P$203</c:f>
                <c:numCache>
                  <c:formatCode>General</c:formatCode>
                  <c:ptCount val="202"/>
                  <c:pt idx="0">
                    <c:v>0</c:v>
                  </c:pt>
                  <c:pt idx="3">
                    <c:v>9.5394869045072692E-3</c:v>
                  </c:pt>
                  <c:pt idx="6">
                    <c:v>2.1931514431505539E-2</c:v>
                  </c:pt>
                  <c:pt idx="9">
                    <c:v>1.1797272656525401E-2</c:v>
                  </c:pt>
                  <c:pt idx="12">
                    <c:v>2.9278418054408589E-2</c:v>
                  </c:pt>
                  <c:pt idx="15">
                    <c:v>4.4954604019132462E-2</c:v>
                  </c:pt>
                  <c:pt idx="18">
                    <c:v>6.0947830899348854E-2</c:v>
                  </c:pt>
                  <c:pt idx="21">
                    <c:v>7.112952300208196E-2</c:v>
                  </c:pt>
                  <c:pt idx="24">
                    <c:v>8.9209274293698709E-2</c:v>
                  </c:pt>
                  <c:pt idx="27">
                    <c:v>4.0051725100600566E-2</c:v>
                  </c:pt>
                  <c:pt idx="30">
                    <c:v>6.0815989899294209E-2</c:v>
                  </c:pt>
                  <c:pt idx="33">
                    <c:v>7.7934359380937068E-2</c:v>
                  </c:pt>
                  <c:pt idx="36">
                    <c:v>6.4547174643521707E-2</c:v>
                  </c:pt>
                  <c:pt idx="39">
                    <c:v>5.9422006981630499E-2</c:v>
                  </c:pt>
                  <c:pt idx="42">
                    <c:v>0.10538760119499713</c:v>
                  </c:pt>
                  <c:pt idx="45">
                    <c:v>8.6493094710849996E-2</c:v>
                  </c:pt>
                  <c:pt idx="50">
                    <c:v>5.2156802067238696E-2</c:v>
                  </c:pt>
                  <c:pt idx="53">
                    <c:v>8.1478431879404414E-2</c:v>
                  </c:pt>
                  <c:pt idx="56">
                    <c:v>4.4102571240000138E-2</c:v>
                  </c:pt>
                  <c:pt idx="59">
                    <c:v>7.5471457241369014E-2</c:v>
                  </c:pt>
                  <c:pt idx="62">
                    <c:v>9.466065232938782E-2</c:v>
                  </c:pt>
                  <c:pt idx="65">
                    <c:v>6.5084201795084895E-2</c:v>
                  </c:pt>
                  <c:pt idx="68">
                    <c:v>5.1505017807469917E-2</c:v>
                  </c:pt>
                  <c:pt idx="71">
                    <c:v>7.5985871813858269E-2</c:v>
                  </c:pt>
                  <c:pt idx="74">
                    <c:v>6.0523878021643517E-2</c:v>
                  </c:pt>
                  <c:pt idx="77">
                    <c:v>0.11535017980954887</c:v>
                  </c:pt>
                  <c:pt idx="80">
                    <c:v>3.7179346565779821E-2</c:v>
                  </c:pt>
                  <c:pt idx="83">
                    <c:v>7.0197934378350063E-2</c:v>
                  </c:pt>
                  <c:pt idx="86">
                    <c:v>8.8963678181197756E-2</c:v>
                  </c:pt>
                  <c:pt idx="89">
                    <c:v>8.1586417380325946E-2</c:v>
                  </c:pt>
                  <c:pt idx="92">
                    <c:v>6.8562428412501111E-2</c:v>
                  </c:pt>
                  <c:pt idx="95">
                    <c:v>8.9966010218629586E-2</c:v>
                  </c:pt>
                  <c:pt idx="98">
                    <c:v>0.10072851458474476</c:v>
                  </c:pt>
                  <c:pt idx="101">
                    <c:v>8.2069676431693939E-2</c:v>
                  </c:pt>
                  <c:pt idx="104">
                    <c:v>8.8830846955126996E-2</c:v>
                  </c:pt>
                  <c:pt idx="107">
                    <c:v>7.5056472499561475E-2</c:v>
                  </c:pt>
                  <c:pt idx="110">
                    <c:v>8.6636115514861917E-2</c:v>
                  </c:pt>
                  <c:pt idx="113">
                    <c:v>5.1509473938143105E-2</c:v>
                  </c:pt>
                  <c:pt idx="116">
                    <c:v>9.2706100335764818E-2</c:v>
                  </c:pt>
                  <c:pt idx="119">
                    <c:v>8.6280545158061731E-2</c:v>
                  </c:pt>
                  <c:pt idx="124">
                    <c:v>0.11293540596463809</c:v>
                  </c:pt>
                  <c:pt idx="127">
                    <c:v>6.6114179584921051E-2</c:v>
                  </c:pt>
                  <c:pt idx="130">
                    <c:v>7.5171103968103295E-2</c:v>
                  </c:pt>
                  <c:pt idx="133">
                    <c:v>5.8071016732328722E-2</c:v>
                  </c:pt>
                  <c:pt idx="136">
                    <c:v>6.7191227051865338E-2</c:v>
                  </c:pt>
                  <c:pt idx="139">
                    <c:v>6.9449615479650589E-2</c:v>
                  </c:pt>
                  <c:pt idx="142">
                    <c:v>7.7057547928376588E-2</c:v>
                  </c:pt>
                  <c:pt idx="147">
                    <c:v>5.068889973283399E-2</c:v>
                  </c:pt>
                  <c:pt idx="150">
                    <c:v>7.8875639037355033E-2</c:v>
                  </c:pt>
                  <c:pt idx="153">
                    <c:v>5.222825627302162E-2</c:v>
                  </c:pt>
                  <c:pt idx="156">
                    <c:v>9.3797283391576433E-2</c:v>
                  </c:pt>
                  <c:pt idx="159">
                    <c:v>0.1103287490214639</c:v>
                  </c:pt>
                  <c:pt idx="162">
                    <c:v>4.9789990568065864E-2</c:v>
                  </c:pt>
                  <c:pt idx="165">
                    <c:v>5.6523787929126913E-2</c:v>
                  </c:pt>
                  <c:pt idx="168">
                    <c:v>3.8997281545648896E-2</c:v>
                  </c:pt>
                  <c:pt idx="171">
                    <c:v>7.9321014543916643E-2</c:v>
                  </c:pt>
                  <c:pt idx="174">
                    <c:v>7.2566413264712318E-2</c:v>
                  </c:pt>
                  <c:pt idx="177">
                    <c:v>7.9756503216740118E-2</c:v>
                  </c:pt>
                  <c:pt idx="180">
                    <c:v>9.6509305177832183E-2</c:v>
                  </c:pt>
                  <c:pt idx="183">
                    <c:v>6.1668823283342306E-2</c:v>
                  </c:pt>
                  <c:pt idx="186">
                    <c:v>0.10429178832263751</c:v>
                  </c:pt>
                  <c:pt idx="189">
                    <c:v>9.167568952440841E-2</c:v>
                  </c:pt>
                  <c:pt idx="192">
                    <c:v>5.7440510232284435E-2</c:v>
                  </c:pt>
                  <c:pt idx="195">
                    <c:v>9.736662770290061E-2</c:v>
                  </c:pt>
                  <c:pt idx="198">
                    <c:v>7.6394389405650381E-2</c:v>
                  </c:pt>
                  <c:pt idx="201">
                    <c:v>5.9323674666273973E-2</c:v>
                  </c:pt>
                </c:numCache>
              </c:numRef>
            </c:plus>
            <c:minus>
              <c:numRef>
                <c:f>'[PRO-MF-U47-2016_Pub_supplementary figure_02_12_2016.xlsx]Sheet1'!$P$2:$P$203</c:f>
                <c:numCache>
                  <c:formatCode>General</c:formatCode>
                  <c:ptCount val="202"/>
                  <c:pt idx="0">
                    <c:v>0</c:v>
                  </c:pt>
                  <c:pt idx="3">
                    <c:v>9.5394869045072692E-3</c:v>
                  </c:pt>
                  <c:pt idx="6">
                    <c:v>2.1931514431505539E-2</c:v>
                  </c:pt>
                  <c:pt idx="9">
                    <c:v>1.1797272656525401E-2</c:v>
                  </c:pt>
                  <c:pt idx="12">
                    <c:v>2.9278418054408589E-2</c:v>
                  </c:pt>
                  <c:pt idx="15">
                    <c:v>4.4954604019132462E-2</c:v>
                  </c:pt>
                  <c:pt idx="18">
                    <c:v>6.0947830899348854E-2</c:v>
                  </c:pt>
                  <c:pt idx="21">
                    <c:v>7.112952300208196E-2</c:v>
                  </c:pt>
                  <c:pt idx="24">
                    <c:v>8.9209274293698709E-2</c:v>
                  </c:pt>
                  <c:pt idx="27">
                    <c:v>4.0051725100600566E-2</c:v>
                  </c:pt>
                  <c:pt idx="30">
                    <c:v>6.0815989899294209E-2</c:v>
                  </c:pt>
                  <c:pt idx="33">
                    <c:v>7.7934359380937068E-2</c:v>
                  </c:pt>
                  <c:pt idx="36">
                    <c:v>6.4547174643521707E-2</c:v>
                  </c:pt>
                  <c:pt idx="39">
                    <c:v>5.9422006981630499E-2</c:v>
                  </c:pt>
                  <c:pt idx="42">
                    <c:v>0.10538760119499713</c:v>
                  </c:pt>
                  <c:pt idx="45">
                    <c:v>8.6493094710849996E-2</c:v>
                  </c:pt>
                  <c:pt idx="50">
                    <c:v>5.2156802067238696E-2</c:v>
                  </c:pt>
                  <c:pt idx="53">
                    <c:v>8.1478431879404414E-2</c:v>
                  </c:pt>
                  <c:pt idx="56">
                    <c:v>4.4102571240000138E-2</c:v>
                  </c:pt>
                  <c:pt idx="59">
                    <c:v>7.5471457241369014E-2</c:v>
                  </c:pt>
                  <c:pt idx="62">
                    <c:v>9.466065232938782E-2</c:v>
                  </c:pt>
                  <c:pt idx="65">
                    <c:v>6.5084201795084895E-2</c:v>
                  </c:pt>
                  <c:pt idx="68">
                    <c:v>5.1505017807469917E-2</c:v>
                  </c:pt>
                  <c:pt idx="71">
                    <c:v>7.5985871813858269E-2</c:v>
                  </c:pt>
                  <c:pt idx="74">
                    <c:v>6.0523878021643517E-2</c:v>
                  </c:pt>
                  <c:pt idx="77">
                    <c:v>0.11535017980954887</c:v>
                  </c:pt>
                  <c:pt idx="80">
                    <c:v>3.7179346565779821E-2</c:v>
                  </c:pt>
                  <c:pt idx="83">
                    <c:v>7.0197934378350063E-2</c:v>
                  </c:pt>
                  <c:pt idx="86">
                    <c:v>8.8963678181197756E-2</c:v>
                  </c:pt>
                  <c:pt idx="89">
                    <c:v>8.1586417380325946E-2</c:v>
                  </c:pt>
                  <c:pt idx="92">
                    <c:v>6.8562428412501111E-2</c:v>
                  </c:pt>
                  <c:pt idx="95">
                    <c:v>8.9966010218629586E-2</c:v>
                  </c:pt>
                  <c:pt idx="98">
                    <c:v>0.10072851458474476</c:v>
                  </c:pt>
                  <c:pt idx="101">
                    <c:v>8.2069676431693939E-2</c:v>
                  </c:pt>
                  <c:pt idx="104">
                    <c:v>8.8830846955126996E-2</c:v>
                  </c:pt>
                  <c:pt idx="107">
                    <c:v>7.5056472499561475E-2</c:v>
                  </c:pt>
                  <c:pt idx="110">
                    <c:v>8.6636115514861917E-2</c:v>
                  </c:pt>
                  <c:pt idx="113">
                    <c:v>5.1509473938143105E-2</c:v>
                  </c:pt>
                  <c:pt idx="116">
                    <c:v>9.2706100335764818E-2</c:v>
                  </c:pt>
                  <c:pt idx="119">
                    <c:v>8.6280545158061731E-2</c:v>
                  </c:pt>
                  <c:pt idx="124">
                    <c:v>0.11293540596463809</c:v>
                  </c:pt>
                  <c:pt idx="127">
                    <c:v>6.6114179584921051E-2</c:v>
                  </c:pt>
                  <c:pt idx="130">
                    <c:v>7.5171103968103295E-2</c:v>
                  </c:pt>
                  <c:pt idx="133">
                    <c:v>5.8071016732328722E-2</c:v>
                  </c:pt>
                  <c:pt idx="136">
                    <c:v>6.7191227051865338E-2</c:v>
                  </c:pt>
                  <c:pt idx="139">
                    <c:v>6.9449615479650589E-2</c:v>
                  </c:pt>
                  <c:pt idx="142">
                    <c:v>7.7057547928376588E-2</c:v>
                  </c:pt>
                  <c:pt idx="147">
                    <c:v>5.068889973283399E-2</c:v>
                  </c:pt>
                  <c:pt idx="150">
                    <c:v>7.8875639037355033E-2</c:v>
                  </c:pt>
                  <c:pt idx="153">
                    <c:v>5.222825627302162E-2</c:v>
                  </c:pt>
                  <c:pt idx="156">
                    <c:v>9.3797283391576433E-2</c:v>
                  </c:pt>
                  <c:pt idx="159">
                    <c:v>0.1103287490214639</c:v>
                  </c:pt>
                  <c:pt idx="162">
                    <c:v>4.9789990568065864E-2</c:v>
                  </c:pt>
                  <c:pt idx="165">
                    <c:v>5.6523787929126913E-2</c:v>
                  </c:pt>
                  <c:pt idx="168">
                    <c:v>3.8997281545648896E-2</c:v>
                  </c:pt>
                  <c:pt idx="171">
                    <c:v>7.9321014543916643E-2</c:v>
                  </c:pt>
                  <c:pt idx="174">
                    <c:v>7.2566413264712318E-2</c:v>
                  </c:pt>
                  <c:pt idx="177">
                    <c:v>7.9756503216740118E-2</c:v>
                  </c:pt>
                  <c:pt idx="180">
                    <c:v>9.6509305177832183E-2</c:v>
                  </c:pt>
                  <c:pt idx="183">
                    <c:v>6.1668823283342306E-2</c:v>
                  </c:pt>
                  <c:pt idx="186">
                    <c:v>0.10429178832263751</c:v>
                  </c:pt>
                  <c:pt idx="189">
                    <c:v>9.167568952440841E-2</c:v>
                  </c:pt>
                  <c:pt idx="192">
                    <c:v>5.7440510232284435E-2</c:v>
                  </c:pt>
                  <c:pt idx="195">
                    <c:v>9.736662770290061E-2</c:v>
                  </c:pt>
                  <c:pt idx="198">
                    <c:v>7.6394389405650381E-2</c:v>
                  </c:pt>
                  <c:pt idx="201">
                    <c:v>5.932367466627397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accent2"/>
                </a:solidFill>
                <a:round/>
              </a:ln>
              <a:effectLst/>
            </c:spPr>
          </c:errBars>
          <c:xVal>
            <c:numRef>
              <c:f>'[PRO-MF-U47-2016_Pub_supplementary figure_02_12_2016.xlsx]Sheet1'!$J$2:$J$203</c:f>
              <c:numCache>
                <c:formatCode>General</c:formatCode>
                <c:ptCount val="202"/>
                <c:pt idx="0">
                  <c:v>3.0009999999999998E-2</c:v>
                </c:pt>
                <c:pt idx="1">
                  <c:v>0.34233999999999998</c:v>
                </c:pt>
                <c:pt idx="2">
                  <c:v>0.67566999999999999</c:v>
                </c:pt>
                <c:pt idx="3">
                  <c:v>1.00908</c:v>
                </c:pt>
                <c:pt idx="4">
                  <c:v>1.3426</c:v>
                </c:pt>
                <c:pt idx="5">
                  <c:v>1.6755899999999999</c:v>
                </c:pt>
                <c:pt idx="6">
                  <c:v>2.0094099999999999</c:v>
                </c:pt>
                <c:pt idx="7">
                  <c:v>2.3427500000000001</c:v>
                </c:pt>
                <c:pt idx="8">
                  <c:v>2.6759599999999999</c:v>
                </c:pt>
                <c:pt idx="9">
                  <c:v>3.0095000000000001</c:v>
                </c:pt>
                <c:pt idx="10">
                  <c:v>3.3424900000000002</c:v>
                </c:pt>
                <c:pt idx="11">
                  <c:v>3.6761300000000001</c:v>
                </c:pt>
                <c:pt idx="12">
                  <c:v>4.0097500000000004</c:v>
                </c:pt>
                <c:pt idx="13">
                  <c:v>4.3426799999999997</c:v>
                </c:pt>
                <c:pt idx="14">
                  <c:v>4.6763000000000003</c:v>
                </c:pt>
                <c:pt idx="15">
                  <c:v>5.0099099999999996</c:v>
                </c:pt>
                <c:pt idx="16">
                  <c:v>5.343</c:v>
                </c:pt>
                <c:pt idx="17">
                  <c:v>5.6763000000000003</c:v>
                </c:pt>
                <c:pt idx="18">
                  <c:v>6.0100800000000003</c:v>
                </c:pt>
                <c:pt idx="19">
                  <c:v>6.3433999999999999</c:v>
                </c:pt>
                <c:pt idx="20">
                  <c:v>6.6766399999999999</c:v>
                </c:pt>
                <c:pt idx="21">
                  <c:v>7.0101199999999997</c:v>
                </c:pt>
                <c:pt idx="22">
                  <c:v>7.3433799999999998</c:v>
                </c:pt>
                <c:pt idx="23">
                  <c:v>7.6769699999999998</c:v>
                </c:pt>
                <c:pt idx="24">
                  <c:v>8.0101800000000001</c:v>
                </c:pt>
                <c:pt idx="25">
                  <c:v>8.34361</c:v>
                </c:pt>
                <c:pt idx="26">
                  <c:v>8.6769300000000005</c:v>
                </c:pt>
                <c:pt idx="27">
                  <c:v>9.0103299999999997</c:v>
                </c:pt>
                <c:pt idx="28">
                  <c:v>9.34389</c:v>
                </c:pt>
                <c:pt idx="29">
                  <c:v>9.6772299999999998</c:v>
                </c:pt>
                <c:pt idx="30">
                  <c:v>10.010479999999999</c:v>
                </c:pt>
                <c:pt idx="31">
                  <c:v>10.343920000000001</c:v>
                </c:pt>
                <c:pt idx="32">
                  <c:v>10.67733</c:v>
                </c:pt>
                <c:pt idx="33">
                  <c:v>11.01094</c:v>
                </c:pt>
                <c:pt idx="34">
                  <c:v>11.34399</c:v>
                </c:pt>
                <c:pt idx="35">
                  <c:v>11.67736</c:v>
                </c:pt>
                <c:pt idx="36">
                  <c:v>12.01094</c:v>
                </c:pt>
                <c:pt idx="37">
                  <c:v>12.34432</c:v>
                </c:pt>
                <c:pt idx="38">
                  <c:v>12.67742</c:v>
                </c:pt>
                <c:pt idx="39">
                  <c:v>13.011240000000001</c:v>
                </c:pt>
                <c:pt idx="40">
                  <c:v>13.34459</c:v>
                </c:pt>
                <c:pt idx="41">
                  <c:v>13.67789</c:v>
                </c:pt>
                <c:pt idx="42">
                  <c:v>14.011279999999999</c:v>
                </c:pt>
                <c:pt idx="43">
                  <c:v>14.34464</c:v>
                </c:pt>
                <c:pt idx="44">
                  <c:v>14.67784</c:v>
                </c:pt>
                <c:pt idx="45">
                  <c:v>15.011520000000001</c:v>
                </c:pt>
                <c:pt idx="46">
                  <c:v>15.344749999999999</c:v>
                </c:pt>
                <c:pt idx="47">
                  <c:v>15.67792</c:v>
                </c:pt>
                <c:pt idx="48">
                  <c:v>16.01155</c:v>
                </c:pt>
                <c:pt idx="49">
                  <c:v>16.344909999999999</c:v>
                </c:pt>
                <c:pt idx="50">
                  <c:v>16.678129999999999</c:v>
                </c:pt>
                <c:pt idx="51">
                  <c:v>17.011659999999999</c:v>
                </c:pt>
                <c:pt idx="52">
                  <c:v>17.345099999999999</c:v>
                </c:pt>
                <c:pt idx="53">
                  <c:v>17.678450000000002</c:v>
                </c:pt>
                <c:pt idx="54">
                  <c:v>18.011620000000001</c:v>
                </c:pt>
                <c:pt idx="55">
                  <c:v>18.345120000000001</c:v>
                </c:pt>
                <c:pt idx="56">
                  <c:v>18.678319999999999</c:v>
                </c:pt>
                <c:pt idx="57">
                  <c:v>19.011880000000001</c:v>
                </c:pt>
                <c:pt idx="58">
                  <c:v>19.345469999999999</c:v>
                </c:pt>
                <c:pt idx="59">
                  <c:v>19.678719999999998</c:v>
                </c:pt>
                <c:pt idx="60">
                  <c:v>20.012049999999999</c:v>
                </c:pt>
                <c:pt idx="61">
                  <c:v>20.345369999999999</c:v>
                </c:pt>
                <c:pt idx="62">
                  <c:v>20.679079999999999</c:v>
                </c:pt>
                <c:pt idx="63">
                  <c:v>21.012309999999999</c:v>
                </c:pt>
                <c:pt idx="64">
                  <c:v>21.34571</c:v>
                </c:pt>
                <c:pt idx="65">
                  <c:v>21.679010000000002</c:v>
                </c:pt>
                <c:pt idx="66">
                  <c:v>22.012460000000001</c:v>
                </c:pt>
                <c:pt idx="67">
                  <c:v>22.346039999999999</c:v>
                </c:pt>
                <c:pt idx="68">
                  <c:v>22.679400000000001</c:v>
                </c:pt>
                <c:pt idx="69">
                  <c:v>23.012409999999999</c:v>
                </c:pt>
                <c:pt idx="70">
                  <c:v>23.34581</c:v>
                </c:pt>
                <c:pt idx="71">
                  <c:v>23.679580000000001</c:v>
                </c:pt>
                <c:pt idx="72">
                  <c:v>24.01285</c:v>
                </c:pt>
                <c:pt idx="73">
                  <c:v>24.345890000000001</c:v>
                </c:pt>
                <c:pt idx="74">
                  <c:v>24.679559999999999</c:v>
                </c:pt>
                <c:pt idx="75">
                  <c:v>25.012879999999999</c:v>
                </c:pt>
                <c:pt idx="76">
                  <c:v>25.346219999999999</c:v>
                </c:pt>
                <c:pt idx="77">
                  <c:v>25.67944</c:v>
                </c:pt>
                <c:pt idx="78">
                  <c:v>26.013069999999999</c:v>
                </c:pt>
                <c:pt idx="79">
                  <c:v>26.346309999999999</c:v>
                </c:pt>
                <c:pt idx="80">
                  <c:v>26.679849999999998</c:v>
                </c:pt>
                <c:pt idx="81">
                  <c:v>27.01305</c:v>
                </c:pt>
                <c:pt idx="82">
                  <c:v>27.346240000000002</c:v>
                </c:pt>
                <c:pt idx="83">
                  <c:v>27.68019</c:v>
                </c:pt>
                <c:pt idx="84">
                  <c:v>28.013439999999999</c:v>
                </c:pt>
                <c:pt idx="85">
                  <c:v>28.346509999999999</c:v>
                </c:pt>
                <c:pt idx="86">
                  <c:v>28.680299999999999</c:v>
                </c:pt>
                <c:pt idx="87">
                  <c:v>29.013539999999999</c:v>
                </c:pt>
                <c:pt idx="88">
                  <c:v>29.346979999999999</c:v>
                </c:pt>
                <c:pt idx="89">
                  <c:v>29.680009999999999</c:v>
                </c:pt>
                <c:pt idx="90">
                  <c:v>30.013639999999999</c:v>
                </c:pt>
                <c:pt idx="91">
                  <c:v>30.347190000000001</c:v>
                </c:pt>
                <c:pt idx="92">
                  <c:v>30.680430000000001</c:v>
                </c:pt>
                <c:pt idx="93">
                  <c:v>31.013839999999998</c:v>
                </c:pt>
                <c:pt idx="94">
                  <c:v>31.347169999999998</c:v>
                </c:pt>
                <c:pt idx="95">
                  <c:v>31.680219999999998</c:v>
                </c:pt>
                <c:pt idx="96">
                  <c:v>32.014060000000001</c:v>
                </c:pt>
                <c:pt idx="97">
                  <c:v>32.347529999999999</c:v>
                </c:pt>
                <c:pt idx="98">
                  <c:v>32.680729999999997</c:v>
                </c:pt>
                <c:pt idx="99">
                  <c:v>33.014209999999999</c:v>
                </c:pt>
                <c:pt idx="100">
                  <c:v>33.34742</c:v>
                </c:pt>
                <c:pt idx="101">
                  <c:v>33.681249999999999</c:v>
                </c:pt>
                <c:pt idx="102">
                  <c:v>34.014339999999997</c:v>
                </c:pt>
                <c:pt idx="103">
                  <c:v>34.34769</c:v>
                </c:pt>
                <c:pt idx="104">
                  <c:v>34.681199999999997</c:v>
                </c:pt>
                <c:pt idx="105">
                  <c:v>35.01464</c:v>
                </c:pt>
                <c:pt idx="106">
                  <c:v>35.348030000000001</c:v>
                </c:pt>
                <c:pt idx="107">
                  <c:v>35.681199999999997</c:v>
                </c:pt>
                <c:pt idx="108">
                  <c:v>36.014530000000001</c:v>
                </c:pt>
                <c:pt idx="109">
                  <c:v>36.348089999999999</c:v>
                </c:pt>
                <c:pt idx="110">
                  <c:v>36.681359999999998</c:v>
                </c:pt>
                <c:pt idx="111">
                  <c:v>37.014690000000002</c:v>
                </c:pt>
                <c:pt idx="112">
                  <c:v>37.347969999999997</c:v>
                </c:pt>
                <c:pt idx="113">
                  <c:v>37.681730000000002</c:v>
                </c:pt>
                <c:pt idx="114">
                  <c:v>38.014949999999999</c:v>
                </c:pt>
                <c:pt idx="115">
                  <c:v>38.348399999999998</c:v>
                </c:pt>
                <c:pt idx="116">
                  <c:v>38.682000000000002</c:v>
                </c:pt>
                <c:pt idx="117">
                  <c:v>39.015169999999998</c:v>
                </c:pt>
                <c:pt idx="118">
                  <c:v>39.348559999999999</c:v>
                </c:pt>
                <c:pt idx="119">
                  <c:v>39.682020000000001</c:v>
                </c:pt>
                <c:pt idx="120">
                  <c:v>40.015349999999998</c:v>
                </c:pt>
                <c:pt idx="121">
                  <c:v>40.348689999999998</c:v>
                </c:pt>
                <c:pt idx="122">
                  <c:v>40.682250000000003</c:v>
                </c:pt>
                <c:pt idx="123">
                  <c:v>41.015340000000002</c:v>
                </c:pt>
                <c:pt idx="124">
                  <c:v>41.349110000000003</c:v>
                </c:pt>
                <c:pt idx="125">
                  <c:v>41.68233</c:v>
                </c:pt>
                <c:pt idx="126">
                  <c:v>42.015639999999998</c:v>
                </c:pt>
                <c:pt idx="127">
                  <c:v>42.348820000000003</c:v>
                </c:pt>
                <c:pt idx="128">
                  <c:v>42.68244</c:v>
                </c:pt>
                <c:pt idx="129">
                  <c:v>43.015770000000003</c:v>
                </c:pt>
                <c:pt idx="130">
                  <c:v>43.349319999999999</c:v>
                </c:pt>
                <c:pt idx="131">
                  <c:v>43.682429999999997</c:v>
                </c:pt>
                <c:pt idx="132">
                  <c:v>44.015700000000002</c:v>
                </c:pt>
                <c:pt idx="133">
                  <c:v>44.349409999999999</c:v>
                </c:pt>
                <c:pt idx="134">
                  <c:v>44.682740000000003</c:v>
                </c:pt>
                <c:pt idx="135">
                  <c:v>45.015929999999997</c:v>
                </c:pt>
                <c:pt idx="136">
                  <c:v>45.349499999999999</c:v>
                </c:pt>
                <c:pt idx="137">
                  <c:v>45.683019999999999</c:v>
                </c:pt>
                <c:pt idx="138">
                  <c:v>46.01632</c:v>
                </c:pt>
                <c:pt idx="139">
                  <c:v>46.349629999999998</c:v>
                </c:pt>
                <c:pt idx="140">
                  <c:v>46.683239999999998</c:v>
                </c:pt>
                <c:pt idx="141">
                  <c:v>47.016240000000003</c:v>
                </c:pt>
                <c:pt idx="142">
                  <c:v>47.349719999999998</c:v>
                </c:pt>
                <c:pt idx="143">
                  <c:v>47.683349999999997</c:v>
                </c:pt>
                <c:pt idx="144">
                  <c:v>48.016629999999999</c:v>
                </c:pt>
                <c:pt idx="145">
                  <c:v>48.349679999999999</c:v>
                </c:pt>
                <c:pt idx="146">
                  <c:v>48.683540000000001</c:v>
                </c:pt>
                <c:pt idx="147">
                  <c:v>49.016579999999998</c:v>
                </c:pt>
                <c:pt idx="148">
                  <c:v>49.35022</c:v>
                </c:pt>
                <c:pt idx="149">
                  <c:v>49.683419999999998</c:v>
                </c:pt>
                <c:pt idx="150">
                  <c:v>50.016750000000002</c:v>
                </c:pt>
                <c:pt idx="151">
                  <c:v>50.35051</c:v>
                </c:pt>
                <c:pt idx="152">
                  <c:v>50.683419999999998</c:v>
                </c:pt>
                <c:pt idx="153">
                  <c:v>51.017330000000001</c:v>
                </c:pt>
                <c:pt idx="154">
                  <c:v>51.350200000000001</c:v>
                </c:pt>
                <c:pt idx="155">
                  <c:v>51.684019999999997</c:v>
                </c:pt>
                <c:pt idx="156">
                  <c:v>52.01708</c:v>
                </c:pt>
                <c:pt idx="157">
                  <c:v>52.350490000000001</c:v>
                </c:pt>
                <c:pt idx="158">
                  <c:v>52.684010000000001</c:v>
                </c:pt>
                <c:pt idx="159">
                  <c:v>53.01726</c:v>
                </c:pt>
                <c:pt idx="160">
                  <c:v>53.35078</c:v>
                </c:pt>
                <c:pt idx="161">
                  <c:v>53.684379999999997</c:v>
                </c:pt>
                <c:pt idx="162">
                  <c:v>54.017249999999997</c:v>
                </c:pt>
                <c:pt idx="163">
                  <c:v>54.350920000000002</c:v>
                </c:pt>
                <c:pt idx="164">
                  <c:v>54.684269999999998</c:v>
                </c:pt>
                <c:pt idx="165">
                  <c:v>55.017539999999997</c:v>
                </c:pt>
                <c:pt idx="166">
                  <c:v>55.350729999999999</c:v>
                </c:pt>
                <c:pt idx="167">
                  <c:v>55.684429999999999</c:v>
                </c:pt>
                <c:pt idx="168">
                  <c:v>56.017679999999999</c:v>
                </c:pt>
                <c:pt idx="169">
                  <c:v>56.35125</c:v>
                </c:pt>
                <c:pt idx="170">
                  <c:v>56.684759999999997</c:v>
                </c:pt>
                <c:pt idx="171">
                  <c:v>57.018050000000002</c:v>
                </c:pt>
                <c:pt idx="172">
                  <c:v>57.351529999999997</c:v>
                </c:pt>
                <c:pt idx="173">
                  <c:v>57.684820000000002</c:v>
                </c:pt>
                <c:pt idx="174">
                  <c:v>58.018140000000002</c:v>
                </c:pt>
                <c:pt idx="175">
                  <c:v>58.351640000000003</c:v>
                </c:pt>
                <c:pt idx="176">
                  <c:v>58.684710000000003</c:v>
                </c:pt>
                <c:pt idx="177">
                  <c:v>59.018340000000002</c:v>
                </c:pt>
                <c:pt idx="178">
                  <c:v>59.351489999999998</c:v>
                </c:pt>
                <c:pt idx="179">
                  <c:v>59.685099999999998</c:v>
                </c:pt>
                <c:pt idx="180">
                  <c:v>60.018729999999998</c:v>
                </c:pt>
                <c:pt idx="181">
                  <c:v>60.35192</c:v>
                </c:pt>
                <c:pt idx="182">
                  <c:v>60.685189999999999</c:v>
                </c:pt>
                <c:pt idx="183">
                  <c:v>61.018700000000003</c:v>
                </c:pt>
                <c:pt idx="184">
                  <c:v>61.352220000000003</c:v>
                </c:pt>
                <c:pt idx="185">
                  <c:v>61.685470000000002</c:v>
                </c:pt>
                <c:pt idx="186">
                  <c:v>62.018439999999998</c:v>
                </c:pt>
                <c:pt idx="187">
                  <c:v>62.352249999999998</c:v>
                </c:pt>
                <c:pt idx="188">
                  <c:v>62.685589999999998</c:v>
                </c:pt>
                <c:pt idx="189">
                  <c:v>63.018949999999997</c:v>
                </c:pt>
                <c:pt idx="190">
                  <c:v>63.3523</c:v>
                </c:pt>
                <c:pt idx="191">
                  <c:v>63.685650000000003</c:v>
                </c:pt>
                <c:pt idx="192">
                  <c:v>64.019620000000003</c:v>
                </c:pt>
                <c:pt idx="193">
                  <c:v>64.352329999999995</c:v>
                </c:pt>
                <c:pt idx="194">
                  <c:v>64.685869999999994</c:v>
                </c:pt>
                <c:pt idx="195">
                  <c:v>65.019199999999998</c:v>
                </c:pt>
                <c:pt idx="196">
                  <c:v>65.352400000000003</c:v>
                </c:pt>
                <c:pt idx="197">
                  <c:v>65.685969999999998</c:v>
                </c:pt>
                <c:pt idx="198">
                  <c:v>66.019649999999999</c:v>
                </c:pt>
                <c:pt idx="199">
                  <c:v>66.352630000000005</c:v>
                </c:pt>
                <c:pt idx="200">
                  <c:v>66.685950000000005</c:v>
                </c:pt>
                <c:pt idx="201">
                  <c:v>67.019549999999995</c:v>
                </c:pt>
              </c:numCache>
            </c:numRef>
          </c:xVal>
          <c:yVal>
            <c:numRef>
              <c:f>'[PRO-MF-U47-2016_Pub_supplementary figure_02_12_2016.xlsx]Sheet1'!$L$2:$L$203</c:f>
              <c:numCache>
                <c:formatCode>General</c:formatCode>
                <c:ptCount val="202"/>
                <c:pt idx="0">
                  <c:v>5.0000000000000044E-2</c:v>
                </c:pt>
                <c:pt idx="3">
                  <c:v>0.15144404115853768</c:v>
                </c:pt>
                <c:pt idx="6">
                  <c:v>9.7879618895298975E-2</c:v>
                </c:pt>
                <c:pt idx="9">
                  <c:v>0.3556246597726424</c:v>
                </c:pt>
                <c:pt idx="12">
                  <c:v>0.71756581806319597</c:v>
                </c:pt>
                <c:pt idx="15">
                  <c:v>0.98568429002299918</c:v>
                </c:pt>
                <c:pt idx="18">
                  <c:v>1.2796830772802894</c:v>
                </c:pt>
                <c:pt idx="21">
                  <c:v>1.5171438637246129</c:v>
                </c:pt>
                <c:pt idx="24">
                  <c:v>1.678489290768264</c:v>
                </c:pt>
                <c:pt idx="27">
                  <c:v>1.7247846372554636</c:v>
                </c:pt>
                <c:pt idx="30">
                  <c:v>1.7835603135593538</c:v>
                </c:pt>
                <c:pt idx="33">
                  <c:v>1.9123546555655715</c:v>
                </c:pt>
                <c:pt idx="36">
                  <c:v>2.0104535141551318</c:v>
                </c:pt>
                <c:pt idx="39">
                  <c:v>2.0568753787226286</c:v>
                </c:pt>
                <c:pt idx="42">
                  <c:v>2.1015990070759312</c:v>
                </c:pt>
                <c:pt idx="45">
                  <c:v>2.1568006702703002</c:v>
                </c:pt>
                <c:pt idx="50">
                  <c:v>2.1855683046472461</c:v>
                </c:pt>
                <c:pt idx="53">
                  <c:v>2.2277279732023691</c:v>
                </c:pt>
                <c:pt idx="56">
                  <c:v>2.2131151868885182</c:v>
                </c:pt>
                <c:pt idx="59">
                  <c:v>2.2238119953667779</c:v>
                </c:pt>
                <c:pt idx="62">
                  <c:v>2.2336339200566018</c:v>
                </c:pt>
                <c:pt idx="65">
                  <c:v>2.2801160810568382</c:v>
                </c:pt>
                <c:pt idx="68">
                  <c:v>2.2813568021234456</c:v>
                </c:pt>
                <c:pt idx="71">
                  <c:v>2.325501321032422</c:v>
                </c:pt>
                <c:pt idx="74">
                  <c:v>2.3725916303529377</c:v>
                </c:pt>
                <c:pt idx="77">
                  <c:v>2.3852509916441038</c:v>
                </c:pt>
                <c:pt idx="80">
                  <c:v>2.4157881151255083</c:v>
                </c:pt>
                <c:pt idx="83">
                  <c:v>2.4413261509646711</c:v>
                </c:pt>
                <c:pt idx="86">
                  <c:v>2.4690770578491463</c:v>
                </c:pt>
                <c:pt idx="89">
                  <c:v>2.4940977832078399</c:v>
                </c:pt>
                <c:pt idx="92">
                  <c:v>2.5455925815655878</c:v>
                </c:pt>
                <c:pt idx="95">
                  <c:v>2.5384718363640104</c:v>
                </c:pt>
                <c:pt idx="98">
                  <c:v>2.5724341929211532</c:v>
                </c:pt>
                <c:pt idx="101">
                  <c:v>2.606260253660349</c:v>
                </c:pt>
                <c:pt idx="104">
                  <c:v>2.591016242365046</c:v>
                </c:pt>
                <c:pt idx="107">
                  <c:v>2.6461176545463343</c:v>
                </c:pt>
                <c:pt idx="110">
                  <c:v>2.6411862305714715</c:v>
                </c:pt>
                <c:pt idx="113">
                  <c:v>2.6512388200090768</c:v>
                </c:pt>
                <c:pt idx="116">
                  <c:v>2.6689111480591317</c:v>
                </c:pt>
                <c:pt idx="119">
                  <c:v>2.691342639103647</c:v>
                </c:pt>
                <c:pt idx="124">
                  <c:v>2.7180932465397838</c:v>
                </c:pt>
                <c:pt idx="127">
                  <c:v>2.7193879700045676</c:v>
                </c:pt>
                <c:pt idx="130">
                  <c:v>2.7062707620935997</c:v>
                </c:pt>
                <c:pt idx="133">
                  <c:v>2.7046215666947448</c:v>
                </c:pt>
                <c:pt idx="136">
                  <c:v>2.7313412514616715</c:v>
                </c:pt>
                <c:pt idx="139">
                  <c:v>2.7405248449499631</c:v>
                </c:pt>
                <c:pt idx="142">
                  <c:v>2.7187479343970287</c:v>
                </c:pt>
                <c:pt idx="147">
                  <c:v>2.7648988219948389</c:v>
                </c:pt>
                <c:pt idx="150">
                  <c:v>2.7444217514810445</c:v>
                </c:pt>
                <c:pt idx="153">
                  <c:v>2.7981671288855408</c:v>
                </c:pt>
                <c:pt idx="156">
                  <c:v>2.7807871268138156</c:v>
                </c:pt>
                <c:pt idx="159">
                  <c:v>2.7831026225499391</c:v>
                </c:pt>
                <c:pt idx="162">
                  <c:v>2.8139258442887822</c:v>
                </c:pt>
                <c:pt idx="165">
                  <c:v>2.8131218529670852</c:v>
                </c:pt>
                <c:pt idx="168">
                  <c:v>2.8397288222413422</c:v>
                </c:pt>
                <c:pt idx="171">
                  <c:v>2.8157351288633921</c:v>
                </c:pt>
                <c:pt idx="174">
                  <c:v>2.8420646805390346</c:v>
                </c:pt>
                <c:pt idx="177">
                  <c:v>2.8471213794381871</c:v>
                </c:pt>
                <c:pt idx="180">
                  <c:v>2.8599340737369237</c:v>
                </c:pt>
                <c:pt idx="183">
                  <c:v>2.8922687254545614</c:v>
                </c:pt>
                <c:pt idx="186">
                  <c:v>2.8578327933470593</c:v>
                </c:pt>
                <c:pt idx="189">
                  <c:v>2.8394567743740118</c:v>
                </c:pt>
                <c:pt idx="192">
                  <c:v>2.8686594441088693</c:v>
                </c:pt>
                <c:pt idx="195">
                  <c:v>2.8749888072303751</c:v>
                </c:pt>
                <c:pt idx="198">
                  <c:v>2.8712914409130255</c:v>
                </c:pt>
                <c:pt idx="201">
                  <c:v>2.8955589394204555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'[PRO-MF-U47-2016_Pub_supplementary figure_02_12_2016.xlsx]Sheet1'!$M$1</c:f>
              <c:strCache>
                <c:ptCount val="1"/>
                <c:pt idx="0">
                  <c:v>PF MS2
(0.5 mM m-toluate)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triang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x"/>
            <c:errBarType val="both"/>
            <c:errValType val="fixedVal"/>
            <c:noEndCap val="0"/>
            <c:val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y"/>
            <c:errBarType val="both"/>
            <c:errValType val="cust"/>
            <c:noEndCap val="0"/>
            <c:plus>
              <c:numRef>
                <c:f>'[PRO-MF-U47-2016_Pub_supplementary figure_02_12_2016.xlsx]Sheet1'!$Q$2:$Q$203</c:f>
                <c:numCache>
                  <c:formatCode>General</c:formatCode>
                  <c:ptCount val="202"/>
                  <c:pt idx="0">
                    <c:v>0</c:v>
                  </c:pt>
                  <c:pt idx="3">
                    <c:v>1.015214994219513E-2</c:v>
                  </c:pt>
                  <c:pt idx="6">
                    <c:v>1.8296664225067993E-2</c:v>
                  </c:pt>
                  <c:pt idx="9">
                    <c:v>2.7059058405026447E-2</c:v>
                  </c:pt>
                  <c:pt idx="12">
                    <c:v>2.7472697656732464E-2</c:v>
                  </c:pt>
                  <c:pt idx="15">
                    <c:v>4.0926863312959361E-2</c:v>
                  </c:pt>
                  <c:pt idx="18">
                    <c:v>5.4955272120685406E-2</c:v>
                  </c:pt>
                  <c:pt idx="21">
                    <c:v>4.8536626106628851E-2</c:v>
                  </c:pt>
                  <c:pt idx="24">
                    <c:v>4.8725059714886824E-2</c:v>
                  </c:pt>
                  <c:pt idx="27">
                    <c:v>7.4170005461696456E-2</c:v>
                  </c:pt>
                  <c:pt idx="30">
                    <c:v>6.7778012456744294E-2</c:v>
                  </c:pt>
                  <c:pt idx="33">
                    <c:v>6.9866171298656729E-2</c:v>
                  </c:pt>
                  <c:pt idx="36">
                    <c:v>6.8736888822720651E-2</c:v>
                  </c:pt>
                  <c:pt idx="39">
                    <c:v>7.7084880683365498E-2</c:v>
                  </c:pt>
                  <c:pt idx="42">
                    <c:v>9.9673841579748804E-2</c:v>
                  </c:pt>
                  <c:pt idx="45">
                    <c:v>8.9171365669550792E-2</c:v>
                  </c:pt>
                  <c:pt idx="50">
                    <c:v>8.4667881612772528E-2</c:v>
                  </c:pt>
                  <c:pt idx="53">
                    <c:v>9.8408661002741232E-2</c:v>
                  </c:pt>
                  <c:pt idx="56">
                    <c:v>9.3340146673415364E-2</c:v>
                  </c:pt>
                  <c:pt idx="59">
                    <c:v>7.3307132088533372E-2</c:v>
                  </c:pt>
                  <c:pt idx="62">
                    <c:v>8.7065165180368775E-2</c:v>
                  </c:pt>
                  <c:pt idx="65">
                    <c:v>0.10694512679095616</c:v>
                  </c:pt>
                  <c:pt idx="68">
                    <c:v>0.10347584988950827</c:v>
                  </c:pt>
                  <c:pt idx="71">
                    <c:v>9.2610827614258734E-2</c:v>
                  </c:pt>
                  <c:pt idx="74">
                    <c:v>9.3279444999359987E-2</c:v>
                  </c:pt>
                  <c:pt idx="77">
                    <c:v>0.12109475803621939</c:v>
                  </c:pt>
                  <c:pt idx="80">
                    <c:v>0.11774153085935202</c:v>
                  </c:pt>
                  <c:pt idx="83">
                    <c:v>8.6918245970111996E-2</c:v>
                  </c:pt>
                  <c:pt idx="86">
                    <c:v>0.10777880087154879</c:v>
                  </c:pt>
                  <c:pt idx="89">
                    <c:v>0.10000645169710785</c:v>
                  </c:pt>
                  <c:pt idx="92">
                    <c:v>0.11860431488897476</c:v>
                  </c:pt>
                  <c:pt idx="95">
                    <c:v>0.11756193619334578</c:v>
                  </c:pt>
                  <c:pt idx="98">
                    <c:v>9.0027126500106802E-2</c:v>
                  </c:pt>
                  <c:pt idx="101">
                    <c:v>9.6735788291360841E-2</c:v>
                  </c:pt>
                  <c:pt idx="104">
                    <c:v>0.1210184963470739</c:v>
                  </c:pt>
                  <c:pt idx="107">
                    <c:v>0.12426199090976868</c:v>
                  </c:pt>
                  <c:pt idx="110">
                    <c:v>0.13271259664614901</c:v>
                  </c:pt>
                  <c:pt idx="113">
                    <c:v>0.10635085988796743</c:v>
                  </c:pt>
                  <c:pt idx="116">
                    <c:v>0.10071084055933185</c:v>
                  </c:pt>
                  <c:pt idx="119">
                    <c:v>0.14640306606450071</c:v>
                  </c:pt>
                  <c:pt idx="124">
                    <c:v>0.13081993386372545</c:v>
                  </c:pt>
                  <c:pt idx="127">
                    <c:v>0.10673030393316037</c:v>
                  </c:pt>
                  <c:pt idx="130">
                    <c:v>0.1280616574771169</c:v>
                  </c:pt>
                  <c:pt idx="133">
                    <c:v>8.3370855264730231E-2</c:v>
                  </c:pt>
                  <c:pt idx="136">
                    <c:v>0.10309086037654365</c:v>
                  </c:pt>
                  <c:pt idx="139">
                    <c:v>0.12144911389609361</c:v>
                  </c:pt>
                  <c:pt idx="142">
                    <c:v>0.13167119932183577</c:v>
                  </c:pt>
                  <c:pt idx="147">
                    <c:v>0.11393465401459699</c:v>
                  </c:pt>
                  <c:pt idx="150">
                    <c:v>0.15269231828200033</c:v>
                  </c:pt>
                  <c:pt idx="153">
                    <c:v>0.12828246084758949</c:v>
                  </c:pt>
                  <c:pt idx="156">
                    <c:v>0.11589020835229355</c:v>
                  </c:pt>
                  <c:pt idx="159">
                    <c:v>0.14731883170836646</c:v>
                  </c:pt>
                  <c:pt idx="162">
                    <c:v>0.14205408170298059</c:v>
                  </c:pt>
                  <c:pt idx="165">
                    <c:v>0.14237431623089752</c:v>
                  </c:pt>
                  <c:pt idx="168">
                    <c:v>0.12060198669187376</c:v>
                  </c:pt>
                  <c:pt idx="171">
                    <c:v>0.14889344993341205</c:v>
                  </c:pt>
                  <c:pt idx="174">
                    <c:v>0.14684257292241765</c:v>
                  </c:pt>
                  <c:pt idx="177">
                    <c:v>0.10220036484114839</c:v>
                  </c:pt>
                  <c:pt idx="180">
                    <c:v>0.14046221826023328</c:v>
                  </c:pt>
                  <c:pt idx="183">
                    <c:v>0.12794954786071644</c:v>
                  </c:pt>
                  <c:pt idx="186">
                    <c:v>0.10911174401083666</c:v>
                  </c:pt>
                  <c:pt idx="189">
                    <c:v>0.1069875037412488</c:v>
                  </c:pt>
                  <c:pt idx="192">
                    <c:v>0.14893645357736518</c:v>
                  </c:pt>
                  <c:pt idx="195">
                    <c:v>0.10716294074736082</c:v>
                  </c:pt>
                  <c:pt idx="198">
                    <c:v>0.15792462093384121</c:v>
                  </c:pt>
                  <c:pt idx="201">
                    <c:v>0.13024030189420874</c:v>
                  </c:pt>
                </c:numCache>
              </c:numRef>
            </c:plus>
            <c:minus>
              <c:numRef>
                <c:f>'[PRO-MF-U47-2016_Pub_supplementary figure_02_12_2016.xlsx]Sheet1'!$Q$2:$Q$203</c:f>
                <c:numCache>
                  <c:formatCode>General</c:formatCode>
                  <c:ptCount val="202"/>
                  <c:pt idx="0">
                    <c:v>0</c:v>
                  </c:pt>
                  <c:pt idx="3">
                    <c:v>1.015214994219513E-2</c:v>
                  </c:pt>
                  <c:pt idx="6">
                    <c:v>1.8296664225067993E-2</c:v>
                  </c:pt>
                  <c:pt idx="9">
                    <c:v>2.7059058405026447E-2</c:v>
                  </c:pt>
                  <c:pt idx="12">
                    <c:v>2.7472697656732464E-2</c:v>
                  </c:pt>
                  <c:pt idx="15">
                    <c:v>4.0926863312959361E-2</c:v>
                  </c:pt>
                  <c:pt idx="18">
                    <c:v>5.4955272120685406E-2</c:v>
                  </c:pt>
                  <c:pt idx="21">
                    <c:v>4.8536626106628851E-2</c:v>
                  </c:pt>
                  <c:pt idx="24">
                    <c:v>4.8725059714886824E-2</c:v>
                  </c:pt>
                  <c:pt idx="27">
                    <c:v>7.4170005461696456E-2</c:v>
                  </c:pt>
                  <c:pt idx="30">
                    <c:v>6.7778012456744294E-2</c:v>
                  </c:pt>
                  <c:pt idx="33">
                    <c:v>6.9866171298656729E-2</c:v>
                  </c:pt>
                  <c:pt idx="36">
                    <c:v>6.8736888822720651E-2</c:v>
                  </c:pt>
                  <c:pt idx="39">
                    <c:v>7.7084880683365498E-2</c:v>
                  </c:pt>
                  <c:pt idx="42">
                    <c:v>9.9673841579748804E-2</c:v>
                  </c:pt>
                  <c:pt idx="45">
                    <c:v>8.9171365669550792E-2</c:v>
                  </c:pt>
                  <c:pt idx="50">
                    <c:v>8.4667881612772528E-2</c:v>
                  </c:pt>
                  <c:pt idx="53">
                    <c:v>9.8408661002741232E-2</c:v>
                  </c:pt>
                  <c:pt idx="56">
                    <c:v>9.3340146673415364E-2</c:v>
                  </c:pt>
                  <c:pt idx="59">
                    <c:v>7.3307132088533372E-2</c:v>
                  </c:pt>
                  <c:pt idx="62">
                    <c:v>8.7065165180368775E-2</c:v>
                  </c:pt>
                  <c:pt idx="65">
                    <c:v>0.10694512679095616</c:v>
                  </c:pt>
                  <c:pt idx="68">
                    <c:v>0.10347584988950827</c:v>
                  </c:pt>
                  <c:pt idx="71">
                    <c:v>9.2610827614258734E-2</c:v>
                  </c:pt>
                  <c:pt idx="74">
                    <c:v>9.3279444999359987E-2</c:v>
                  </c:pt>
                  <c:pt idx="77">
                    <c:v>0.12109475803621939</c:v>
                  </c:pt>
                  <c:pt idx="80">
                    <c:v>0.11774153085935202</c:v>
                  </c:pt>
                  <c:pt idx="83">
                    <c:v>8.6918245970111996E-2</c:v>
                  </c:pt>
                  <c:pt idx="86">
                    <c:v>0.10777880087154879</c:v>
                  </c:pt>
                  <c:pt idx="89">
                    <c:v>0.10000645169710785</c:v>
                  </c:pt>
                  <c:pt idx="92">
                    <c:v>0.11860431488897476</c:v>
                  </c:pt>
                  <c:pt idx="95">
                    <c:v>0.11756193619334578</c:v>
                  </c:pt>
                  <c:pt idx="98">
                    <c:v>9.0027126500106802E-2</c:v>
                  </c:pt>
                  <c:pt idx="101">
                    <c:v>9.6735788291360841E-2</c:v>
                  </c:pt>
                  <c:pt idx="104">
                    <c:v>0.1210184963470739</c:v>
                  </c:pt>
                  <c:pt idx="107">
                    <c:v>0.12426199090976868</c:v>
                  </c:pt>
                  <c:pt idx="110">
                    <c:v>0.13271259664614901</c:v>
                  </c:pt>
                  <c:pt idx="113">
                    <c:v>0.10635085988796743</c:v>
                  </c:pt>
                  <c:pt idx="116">
                    <c:v>0.10071084055933185</c:v>
                  </c:pt>
                  <c:pt idx="119">
                    <c:v>0.14640306606450071</c:v>
                  </c:pt>
                  <c:pt idx="124">
                    <c:v>0.13081993386372545</c:v>
                  </c:pt>
                  <c:pt idx="127">
                    <c:v>0.10673030393316037</c:v>
                  </c:pt>
                  <c:pt idx="130">
                    <c:v>0.1280616574771169</c:v>
                  </c:pt>
                  <c:pt idx="133">
                    <c:v>8.3370855264730231E-2</c:v>
                  </c:pt>
                  <c:pt idx="136">
                    <c:v>0.10309086037654365</c:v>
                  </c:pt>
                  <c:pt idx="139">
                    <c:v>0.12144911389609361</c:v>
                  </c:pt>
                  <c:pt idx="142">
                    <c:v>0.13167119932183577</c:v>
                  </c:pt>
                  <c:pt idx="147">
                    <c:v>0.11393465401459699</c:v>
                  </c:pt>
                  <c:pt idx="150">
                    <c:v>0.15269231828200033</c:v>
                  </c:pt>
                  <c:pt idx="153">
                    <c:v>0.12828246084758949</c:v>
                  </c:pt>
                  <c:pt idx="156">
                    <c:v>0.11589020835229355</c:v>
                  </c:pt>
                  <c:pt idx="159">
                    <c:v>0.14731883170836646</c:v>
                  </c:pt>
                  <c:pt idx="162">
                    <c:v>0.14205408170298059</c:v>
                  </c:pt>
                  <c:pt idx="165">
                    <c:v>0.14237431623089752</c:v>
                  </c:pt>
                  <c:pt idx="168">
                    <c:v>0.12060198669187376</c:v>
                  </c:pt>
                  <c:pt idx="171">
                    <c:v>0.14889344993341205</c:v>
                  </c:pt>
                  <c:pt idx="174">
                    <c:v>0.14684257292241765</c:v>
                  </c:pt>
                  <c:pt idx="177">
                    <c:v>0.10220036484114839</c:v>
                  </c:pt>
                  <c:pt idx="180">
                    <c:v>0.14046221826023328</c:v>
                  </c:pt>
                  <c:pt idx="183">
                    <c:v>0.12794954786071644</c:v>
                  </c:pt>
                  <c:pt idx="186">
                    <c:v>0.10911174401083666</c:v>
                  </c:pt>
                  <c:pt idx="189">
                    <c:v>0.1069875037412488</c:v>
                  </c:pt>
                  <c:pt idx="192">
                    <c:v>0.14893645357736518</c:v>
                  </c:pt>
                  <c:pt idx="195">
                    <c:v>0.10716294074736082</c:v>
                  </c:pt>
                  <c:pt idx="198">
                    <c:v>0.15792462093384121</c:v>
                  </c:pt>
                  <c:pt idx="201">
                    <c:v>0.1302403018942087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accent3"/>
                </a:solidFill>
                <a:round/>
              </a:ln>
              <a:effectLst/>
            </c:spPr>
          </c:errBars>
          <c:xVal>
            <c:numRef>
              <c:f>'[PRO-MF-U47-2016_Pub_supplementary figure_02_12_2016.xlsx]Sheet1'!$J$2:$J$203</c:f>
              <c:numCache>
                <c:formatCode>General</c:formatCode>
                <c:ptCount val="202"/>
                <c:pt idx="0">
                  <c:v>3.0009999999999998E-2</c:v>
                </c:pt>
                <c:pt idx="1">
                  <c:v>0.34233999999999998</c:v>
                </c:pt>
                <c:pt idx="2">
                  <c:v>0.67566999999999999</c:v>
                </c:pt>
                <c:pt idx="3">
                  <c:v>1.00908</c:v>
                </c:pt>
                <c:pt idx="4">
                  <c:v>1.3426</c:v>
                </c:pt>
                <c:pt idx="5">
                  <c:v>1.6755899999999999</c:v>
                </c:pt>
                <c:pt idx="6">
                  <c:v>2.0094099999999999</c:v>
                </c:pt>
                <c:pt idx="7">
                  <c:v>2.3427500000000001</c:v>
                </c:pt>
                <c:pt idx="8">
                  <c:v>2.6759599999999999</c:v>
                </c:pt>
                <c:pt idx="9">
                  <c:v>3.0095000000000001</c:v>
                </c:pt>
                <c:pt idx="10">
                  <c:v>3.3424900000000002</c:v>
                </c:pt>
                <c:pt idx="11">
                  <c:v>3.6761300000000001</c:v>
                </c:pt>
                <c:pt idx="12">
                  <c:v>4.0097500000000004</c:v>
                </c:pt>
                <c:pt idx="13">
                  <c:v>4.3426799999999997</c:v>
                </c:pt>
                <c:pt idx="14">
                  <c:v>4.6763000000000003</c:v>
                </c:pt>
                <c:pt idx="15">
                  <c:v>5.0099099999999996</c:v>
                </c:pt>
                <c:pt idx="16">
                  <c:v>5.343</c:v>
                </c:pt>
                <c:pt idx="17">
                  <c:v>5.6763000000000003</c:v>
                </c:pt>
                <c:pt idx="18">
                  <c:v>6.0100800000000003</c:v>
                </c:pt>
                <c:pt idx="19">
                  <c:v>6.3433999999999999</c:v>
                </c:pt>
                <c:pt idx="20">
                  <c:v>6.6766399999999999</c:v>
                </c:pt>
                <c:pt idx="21">
                  <c:v>7.0101199999999997</c:v>
                </c:pt>
                <c:pt idx="22">
                  <c:v>7.3433799999999998</c:v>
                </c:pt>
                <c:pt idx="23">
                  <c:v>7.6769699999999998</c:v>
                </c:pt>
                <c:pt idx="24">
                  <c:v>8.0101800000000001</c:v>
                </c:pt>
                <c:pt idx="25">
                  <c:v>8.34361</c:v>
                </c:pt>
                <c:pt idx="26">
                  <c:v>8.6769300000000005</c:v>
                </c:pt>
                <c:pt idx="27">
                  <c:v>9.0103299999999997</c:v>
                </c:pt>
                <c:pt idx="28">
                  <c:v>9.34389</c:v>
                </c:pt>
                <c:pt idx="29">
                  <c:v>9.6772299999999998</c:v>
                </c:pt>
                <c:pt idx="30">
                  <c:v>10.010479999999999</c:v>
                </c:pt>
                <c:pt idx="31">
                  <c:v>10.343920000000001</c:v>
                </c:pt>
                <c:pt idx="32">
                  <c:v>10.67733</c:v>
                </c:pt>
                <c:pt idx="33">
                  <c:v>11.01094</c:v>
                </c:pt>
                <c:pt idx="34">
                  <c:v>11.34399</c:v>
                </c:pt>
                <c:pt idx="35">
                  <c:v>11.67736</c:v>
                </c:pt>
                <c:pt idx="36">
                  <c:v>12.01094</c:v>
                </c:pt>
                <c:pt idx="37">
                  <c:v>12.34432</c:v>
                </c:pt>
                <c:pt idx="38">
                  <c:v>12.67742</c:v>
                </c:pt>
                <c:pt idx="39">
                  <c:v>13.011240000000001</c:v>
                </c:pt>
                <c:pt idx="40">
                  <c:v>13.34459</c:v>
                </c:pt>
                <c:pt idx="41">
                  <c:v>13.67789</c:v>
                </c:pt>
                <c:pt idx="42">
                  <c:v>14.011279999999999</c:v>
                </c:pt>
                <c:pt idx="43">
                  <c:v>14.34464</c:v>
                </c:pt>
                <c:pt idx="44">
                  <c:v>14.67784</c:v>
                </c:pt>
                <c:pt idx="45">
                  <c:v>15.011520000000001</c:v>
                </c:pt>
                <c:pt idx="46">
                  <c:v>15.344749999999999</c:v>
                </c:pt>
                <c:pt idx="47">
                  <c:v>15.67792</c:v>
                </c:pt>
                <c:pt idx="48">
                  <c:v>16.01155</c:v>
                </c:pt>
                <c:pt idx="49">
                  <c:v>16.344909999999999</c:v>
                </c:pt>
                <c:pt idx="50">
                  <c:v>16.678129999999999</c:v>
                </c:pt>
                <c:pt idx="51">
                  <c:v>17.011659999999999</c:v>
                </c:pt>
                <c:pt idx="52">
                  <c:v>17.345099999999999</c:v>
                </c:pt>
                <c:pt idx="53">
                  <c:v>17.678450000000002</c:v>
                </c:pt>
                <c:pt idx="54">
                  <c:v>18.011620000000001</c:v>
                </c:pt>
                <c:pt idx="55">
                  <c:v>18.345120000000001</c:v>
                </c:pt>
                <c:pt idx="56">
                  <c:v>18.678319999999999</c:v>
                </c:pt>
                <c:pt idx="57">
                  <c:v>19.011880000000001</c:v>
                </c:pt>
                <c:pt idx="58">
                  <c:v>19.345469999999999</c:v>
                </c:pt>
                <c:pt idx="59">
                  <c:v>19.678719999999998</c:v>
                </c:pt>
                <c:pt idx="60">
                  <c:v>20.012049999999999</c:v>
                </c:pt>
                <c:pt idx="61">
                  <c:v>20.345369999999999</c:v>
                </c:pt>
                <c:pt idx="62">
                  <c:v>20.679079999999999</c:v>
                </c:pt>
                <c:pt idx="63">
                  <c:v>21.012309999999999</c:v>
                </c:pt>
                <c:pt idx="64">
                  <c:v>21.34571</c:v>
                </c:pt>
                <c:pt idx="65">
                  <c:v>21.679010000000002</c:v>
                </c:pt>
                <c:pt idx="66">
                  <c:v>22.012460000000001</c:v>
                </c:pt>
                <c:pt idx="67">
                  <c:v>22.346039999999999</c:v>
                </c:pt>
                <c:pt idx="68">
                  <c:v>22.679400000000001</c:v>
                </c:pt>
                <c:pt idx="69">
                  <c:v>23.012409999999999</c:v>
                </c:pt>
                <c:pt idx="70">
                  <c:v>23.34581</c:v>
                </c:pt>
                <c:pt idx="71">
                  <c:v>23.679580000000001</c:v>
                </c:pt>
                <c:pt idx="72">
                  <c:v>24.01285</c:v>
                </c:pt>
                <c:pt idx="73">
                  <c:v>24.345890000000001</c:v>
                </c:pt>
                <c:pt idx="74">
                  <c:v>24.679559999999999</c:v>
                </c:pt>
                <c:pt idx="75">
                  <c:v>25.012879999999999</c:v>
                </c:pt>
                <c:pt idx="76">
                  <c:v>25.346219999999999</c:v>
                </c:pt>
                <c:pt idx="77">
                  <c:v>25.67944</c:v>
                </c:pt>
                <c:pt idx="78">
                  <c:v>26.013069999999999</c:v>
                </c:pt>
                <c:pt idx="79">
                  <c:v>26.346309999999999</c:v>
                </c:pt>
                <c:pt idx="80">
                  <c:v>26.679849999999998</c:v>
                </c:pt>
                <c:pt idx="81">
                  <c:v>27.01305</c:v>
                </c:pt>
                <c:pt idx="82">
                  <c:v>27.346240000000002</c:v>
                </c:pt>
                <c:pt idx="83">
                  <c:v>27.68019</c:v>
                </c:pt>
                <c:pt idx="84">
                  <c:v>28.013439999999999</c:v>
                </c:pt>
                <c:pt idx="85">
                  <c:v>28.346509999999999</c:v>
                </c:pt>
                <c:pt idx="86">
                  <c:v>28.680299999999999</c:v>
                </c:pt>
                <c:pt idx="87">
                  <c:v>29.013539999999999</c:v>
                </c:pt>
                <c:pt idx="88">
                  <c:v>29.346979999999999</c:v>
                </c:pt>
                <c:pt idx="89">
                  <c:v>29.680009999999999</c:v>
                </c:pt>
                <c:pt idx="90">
                  <c:v>30.013639999999999</c:v>
                </c:pt>
                <c:pt idx="91">
                  <c:v>30.347190000000001</c:v>
                </c:pt>
                <c:pt idx="92">
                  <c:v>30.680430000000001</c:v>
                </c:pt>
                <c:pt idx="93">
                  <c:v>31.013839999999998</c:v>
                </c:pt>
                <c:pt idx="94">
                  <c:v>31.347169999999998</c:v>
                </c:pt>
                <c:pt idx="95">
                  <c:v>31.680219999999998</c:v>
                </c:pt>
                <c:pt idx="96">
                  <c:v>32.014060000000001</c:v>
                </c:pt>
                <c:pt idx="97">
                  <c:v>32.347529999999999</c:v>
                </c:pt>
                <c:pt idx="98">
                  <c:v>32.680729999999997</c:v>
                </c:pt>
                <c:pt idx="99">
                  <c:v>33.014209999999999</c:v>
                </c:pt>
                <c:pt idx="100">
                  <c:v>33.34742</c:v>
                </c:pt>
                <c:pt idx="101">
                  <c:v>33.681249999999999</c:v>
                </c:pt>
                <c:pt idx="102">
                  <c:v>34.014339999999997</c:v>
                </c:pt>
                <c:pt idx="103">
                  <c:v>34.34769</c:v>
                </c:pt>
                <c:pt idx="104">
                  <c:v>34.681199999999997</c:v>
                </c:pt>
                <c:pt idx="105">
                  <c:v>35.01464</c:v>
                </c:pt>
                <c:pt idx="106">
                  <c:v>35.348030000000001</c:v>
                </c:pt>
                <c:pt idx="107">
                  <c:v>35.681199999999997</c:v>
                </c:pt>
                <c:pt idx="108">
                  <c:v>36.014530000000001</c:v>
                </c:pt>
                <c:pt idx="109">
                  <c:v>36.348089999999999</c:v>
                </c:pt>
                <c:pt idx="110">
                  <c:v>36.681359999999998</c:v>
                </c:pt>
                <c:pt idx="111">
                  <c:v>37.014690000000002</c:v>
                </c:pt>
                <c:pt idx="112">
                  <c:v>37.347969999999997</c:v>
                </c:pt>
                <c:pt idx="113">
                  <c:v>37.681730000000002</c:v>
                </c:pt>
                <c:pt idx="114">
                  <c:v>38.014949999999999</c:v>
                </c:pt>
                <c:pt idx="115">
                  <c:v>38.348399999999998</c:v>
                </c:pt>
                <c:pt idx="116">
                  <c:v>38.682000000000002</c:v>
                </c:pt>
                <c:pt idx="117">
                  <c:v>39.015169999999998</c:v>
                </c:pt>
                <c:pt idx="118">
                  <c:v>39.348559999999999</c:v>
                </c:pt>
                <c:pt idx="119">
                  <c:v>39.682020000000001</c:v>
                </c:pt>
                <c:pt idx="120">
                  <c:v>40.015349999999998</c:v>
                </c:pt>
                <c:pt idx="121">
                  <c:v>40.348689999999998</c:v>
                </c:pt>
                <c:pt idx="122">
                  <c:v>40.682250000000003</c:v>
                </c:pt>
                <c:pt idx="123">
                  <c:v>41.015340000000002</c:v>
                </c:pt>
                <c:pt idx="124">
                  <c:v>41.349110000000003</c:v>
                </c:pt>
                <c:pt idx="125">
                  <c:v>41.68233</c:v>
                </c:pt>
                <c:pt idx="126">
                  <c:v>42.015639999999998</c:v>
                </c:pt>
                <c:pt idx="127">
                  <c:v>42.348820000000003</c:v>
                </c:pt>
                <c:pt idx="128">
                  <c:v>42.68244</c:v>
                </c:pt>
                <c:pt idx="129">
                  <c:v>43.015770000000003</c:v>
                </c:pt>
                <c:pt idx="130">
                  <c:v>43.349319999999999</c:v>
                </c:pt>
                <c:pt idx="131">
                  <c:v>43.682429999999997</c:v>
                </c:pt>
                <c:pt idx="132">
                  <c:v>44.015700000000002</c:v>
                </c:pt>
                <c:pt idx="133">
                  <c:v>44.349409999999999</c:v>
                </c:pt>
                <c:pt idx="134">
                  <c:v>44.682740000000003</c:v>
                </c:pt>
                <c:pt idx="135">
                  <c:v>45.015929999999997</c:v>
                </c:pt>
                <c:pt idx="136">
                  <c:v>45.349499999999999</c:v>
                </c:pt>
                <c:pt idx="137">
                  <c:v>45.683019999999999</c:v>
                </c:pt>
                <c:pt idx="138">
                  <c:v>46.01632</c:v>
                </c:pt>
                <c:pt idx="139">
                  <c:v>46.349629999999998</c:v>
                </c:pt>
                <c:pt idx="140">
                  <c:v>46.683239999999998</c:v>
                </c:pt>
                <c:pt idx="141">
                  <c:v>47.016240000000003</c:v>
                </c:pt>
                <c:pt idx="142">
                  <c:v>47.349719999999998</c:v>
                </c:pt>
                <c:pt idx="143">
                  <c:v>47.683349999999997</c:v>
                </c:pt>
                <c:pt idx="144">
                  <c:v>48.016629999999999</c:v>
                </c:pt>
                <c:pt idx="145">
                  <c:v>48.349679999999999</c:v>
                </c:pt>
                <c:pt idx="146">
                  <c:v>48.683540000000001</c:v>
                </c:pt>
                <c:pt idx="147">
                  <c:v>49.016579999999998</c:v>
                </c:pt>
                <c:pt idx="148">
                  <c:v>49.35022</c:v>
                </c:pt>
                <c:pt idx="149">
                  <c:v>49.683419999999998</c:v>
                </c:pt>
                <c:pt idx="150">
                  <c:v>50.016750000000002</c:v>
                </c:pt>
                <c:pt idx="151">
                  <c:v>50.35051</c:v>
                </c:pt>
                <c:pt idx="152">
                  <c:v>50.683419999999998</c:v>
                </c:pt>
                <c:pt idx="153">
                  <c:v>51.017330000000001</c:v>
                </c:pt>
                <c:pt idx="154">
                  <c:v>51.350200000000001</c:v>
                </c:pt>
                <c:pt idx="155">
                  <c:v>51.684019999999997</c:v>
                </c:pt>
                <c:pt idx="156">
                  <c:v>52.01708</c:v>
                </c:pt>
                <c:pt idx="157">
                  <c:v>52.350490000000001</c:v>
                </c:pt>
                <c:pt idx="158">
                  <c:v>52.684010000000001</c:v>
                </c:pt>
                <c:pt idx="159">
                  <c:v>53.01726</c:v>
                </c:pt>
                <c:pt idx="160">
                  <c:v>53.35078</c:v>
                </c:pt>
                <c:pt idx="161">
                  <c:v>53.684379999999997</c:v>
                </c:pt>
                <c:pt idx="162">
                  <c:v>54.017249999999997</c:v>
                </c:pt>
                <c:pt idx="163">
                  <c:v>54.350920000000002</c:v>
                </c:pt>
                <c:pt idx="164">
                  <c:v>54.684269999999998</c:v>
                </c:pt>
                <c:pt idx="165">
                  <c:v>55.017539999999997</c:v>
                </c:pt>
                <c:pt idx="166">
                  <c:v>55.350729999999999</c:v>
                </c:pt>
                <c:pt idx="167">
                  <c:v>55.684429999999999</c:v>
                </c:pt>
                <c:pt idx="168">
                  <c:v>56.017679999999999</c:v>
                </c:pt>
                <c:pt idx="169">
                  <c:v>56.35125</c:v>
                </c:pt>
                <c:pt idx="170">
                  <c:v>56.684759999999997</c:v>
                </c:pt>
                <c:pt idx="171">
                  <c:v>57.018050000000002</c:v>
                </c:pt>
                <c:pt idx="172">
                  <c:v>57.351529999999997</c:v>
                </c:pt>
                <c:pt idx="173">
                  <c:v>57.684820000000002</c:v>
                </c:pt>
                <c:pt idx="174">
                  <c:v>58.018140000000002</c:v>
                </c:pt>
                <c:pt idx="175">
                  <c:v>58.351640000000003</c:v>
                </c:pt>
                <c:pt idx="176">
                  <c:v>58.684710000000003</c:v>
                </c:pt>
                <c:pt idx="177">
                  <c:v>59.018340000000002</c:v>
                </c:pt>
                <c:pt idx="178">
                  <c:v>59.351489999999998</c:v>
                </c:pt>
                <c:pt idx="179">
                  <c:v>59.685099999999998</c:v>
                </c:pt>
                <c:pt idx="180">
                  <c:v>60.018729999999998</c:v>
                </c:pt>
                <c:pt idx="181">
                  <c:v>60.35192</c:v>
                </c:pt>
                <c:pt idx="182">
                  <c:v>60.685189999999999</c:v>
                </c:pt>
                <c:pt idx="183">
                  <c:v>61.018700000000003</c:v>
                </c:pt>
                <c:pt idx="184">
                  <c:v>61.352220000000003</c:v>
                </c:pt>
                <c:pt idx="185">
                  <c:v>61.685470000000002</c:v>
                </c:pt>
                <c:pt idx="186">
                  <c:v>62.018439999999998</c:v>
                </c:pt>
                <c:pt idx="187">
                  <c:v>62.352249999999998</c:v>
                </c:pt>
                <c:pt idx="188">
                  <c:v>62.685589999999998</c:v>
                </c:pt>
                <c:pt idx="189">
                  <c:v>63.018949999999997</c:v>
                </c:pt>
                <c:pt idx="190">
                  <c:v>63.3523</c:v>
                </c:pt>
                <c:pt idx="191">
                  <c:v>63.685650000000003</c:v>
                </c:pt>
                <c:pt idx="192">
                  <c:v>64.019620000000003</c:v>
                </c:pt>
                <c:pt idx="193">
                  <c:v>64.352329999999995</c:v>
                </c:pt>
                <c:pt idx="194">
                  <c:v>64.685869999999994</c:v>
                </c:pt>
                <c:pt idx="195">
                  <c:v>65.019199999999998</c:v>
                </c:pt>
                <c:pt idx="196">
                  <c:v>65.352400000000003</c:v>
                </c:pt>
                <c:pt idx="197">
                  <c:v>65.685969999999998</c:v>
                </c:pt>
                <c:pt idx="198">
                  <c:v>66.019649999999999</c:v>
                </c:pt>
                <c:pt idx="199">
                  <c:v>66.352630000000005</c:v>
                </c:pt>
                <c:pt idx="200">
                  <c:v>66.685950000000005</c:v>
                </c:pt>
                <c:pt idx="201">
                  <c:v>67.019549999999995</c:v>
                </c:pt>
              </c:numCache>
            </c:numRef>
          </c:xVal>
          <c:yVal>
            <c:numRef>
              <c:f>'[PRO-MF-U47-2016_Pub_supplementary figure_02_12_2016.xlsx]Sheet1'!$M$2:$M$203</c:f>
              <c:numCache>
                <c:formatCode>General</c:formatCode>
                <c:ptCount val="202"/>
                <c:pt idx="0">
                  <c:v>5.0000000000000044E-2</c:v>
                </c:pt>
                <c:pt idx="3">
                  <c:v>0.15514627289481098</c:v>
                </c:pt>
                <c:pt idx="6">
                  <c:v>7.1605941826907854E-2</c:v>
                </c:pt>
                <c:pt idx="9">
                  <c:v>0.15894379743200332</c:v>
                </c:pt>
                <c:pt idx="12">
                  <c:v>0.32203037323155514</c:v>
                </c:pt>
                <c:pt idx="15">
                  <c:v>0.49536955427707235</c:v>
                </c:pt>
                <c:pt idx="18">
                  <c:v>0.65020344862775592</c:v>
                </c:pt>
                <c:pt idx="21">
                  <c:v>0.78851706981376479</c:v>
                </c:pt>
                <c:pt idx="24">
                  <c:v>0.93194306657906489</c:v>
                </c:pt>
                <c:pt idx="27">
                  <c:v>1.0210292919920829</c:v>
                </c:pt>
                <c:pt idx="30">
                  <c:v>1.1257715058470175</c:v>
                </c:pt>
                <c:pt idx="33">
                  <c:v>1.2267727496039262</c:v>
                </c:pt>
                <c:pt idx="36">
                  <c:v>1.2952896399086065</c:v>
                </c:pt>
                <c:pt idx="39">
                  <c:v>1.3438763499509643</c:v>
                </c:pt>
                <c:pt idx="42">
                  <c:v>1.3924450683077565</c:v>
                </c:pt>
                <c:pt idx="45">
                  <c:v>1.4201764138443735</c:v>
                </c:pt>
                <c:pt idx="50">
                  <c:v>1.4766661762990798</c:v>
                </c:pt>
                <c:pt idx="53">
                  <c:v>1.4938069848417794</c:v>
                </c:pt>
                <c:pt idx="56">
                  <c:v>1.5140986335083135</c:v>
                </c:pt>
                <c:pt idx="59">
                  <c:v>1.5485299365447156</c:v>
                </c:pt>
                <c:pt idx="62">
                  <c:v>1.5655916159877563</c:v>
                </c:pt>
                <c:pt idx="65">
                  <c:v>1.5536950528148421</c:v>
                </c:pt>
                <c:pt idx="68">
                  <c:v>1.5953418135219781</c:v>
                </c:pt>
                <c:pt idx="71">
                  <c:v>1.6271020248963559</c:v>
                </c:pt>
                <c:pt idx="74">
                  <c:v>1.6154072248730962</c:v>
                </c:pt>
                <c:pt idx="77">
                  <c:v>1.6288346055112681</c:v>
                </c:pt>
                <c:pt idx="80">
                  <c:v>1.6337394112416139</c:v>
                </c:pt>
                <c:pt idx="83">
                  <c:v>1.6488308541690631</c:v>
                </c:pt>
                <c:pt idx="86">
                  <c:v>1.6615220289300026</c:v>
                </c:pt>
                <c:pt idx="89">
                  <c:v>1.6520571321165542</c:v>
                </c:pt>
                <c:pt idx="92">
                  <c:v>1.6734009596498192</c:v>
                </c:pt>
                <c:pt idx="95">
                  <c:v>1.6876486415307188</c:v>
                </c:pt>
                <c:pt idx="98">
                  <c:v>1.7042245676362051</c:v>
                </c:pt>
                <c:pt idx="101">
                  <c:v>1.6941096295485796</c:v>
                </c:pt>
                <c:pt idx="104">
                  <c:v>1.7094882535456044</c:v>
                </c:pt>
                <c:pt idx="107">
                  <c:v>1.7285850512596075</c:v>
                </c:pt>
                <c:pt idx="110">
                  <c:v>1.735511442030609</c:v>
                </c:pt>
                <c:pt idx="113">
                  <c:v>1.7521967962397982</c:v>
                </c:pt>
                <c:pt idx="116">
                  <c:v>1.7261260916093706</c:v>
                </c:pt>
                <c:pt idx="119">
                  <c:v>1.7515947092405897</c:v>
                </c:pt>
                <c:pt idx="124">
                  <c:v>1.7298686936010816</c:v>
                </c:pt>
                <c:pt idx="127">
                  <c:v>1.7570726063203483</c:v>
                </c:pt>
                <c:pt idx="130">
                  <c:v>1.7706479752436062</c:v>
                </c:pt>
                <c:pt idx="133">
                  <c:v>1.7656674937689592</c:v>
                </c:pt>
                <c:pt idx="136">
                  <c:v>1.7846428891771835</c:v>
                </c:pt>
                <c:pt idx="139">
                  <c:v>1.7698454346432735</c:v>
                </c:pt>
                <c:pt idx="142">
                  <c:v>1.8021565867462424</c:v>
                </c:pt>
                <c:pt idx="147">
                  <c:v>1.790306018157295</c:v>
                </c:pt>
                <c:pt idx="150">
                  <c:v>1.7697177289646042</c:v>
                </c:pt>
                <c:pt idx="153">
                  <c:v>1.8487963003286476</c:v>
                </c:pt>
                <c:pt idx="156">
                  <c:v>1.8220031835179156</c:v>
                </c:pt>
                <c:pt idx="159">
                  <c:v>1.8336290301976406</c:v>
                </c:pt>
                <c:pt idx="162">
                  <c:v>1.8271163627566802</c:v>
                </c:pt>
                <c:pt idx="165">
                  <c:v>1.8406154817441955</c:v>
                </c:pt>
                <c:pt idx="168">
                  <c:v>1.8553861596706414</c:v>
                </c:pt>
                <c:pt idx="171">
                  <c:v>1.8571836079868103</c:v>
                </c:pt>
                <c:pt idx="174">
                  <c:v>1.8786046619739012</c:v>
                </c:pt>
                <c:pt idx="177">
                  <c:v>1.8383102168395928</c:v>
                </c:pt>
                <c:pt idx="180">
                  <c:v>1.8750562299597382</c:v>
                </c:pt>
                <c:pt idx="183">
                  <c:v>1.8869297590032195</c:v>
                </c:pt>
                <c:pt idx="186">
                  <c:v>1.8639762015131391</c:v>
                </c:pt>
                <c:pt idx="189">
                  <c:v>1.8443817949512598</c:v>
                </c:pt>
                <c:pt idx="192">
                  <c:v>1.9011587614551868</c:v>
                </c:pt>
                <c:pt idx="195">
                  <c:v>1.8604298939702648</c:v>
                </c:pt>
                <c:pt idx="198">
                  <c:v>1.8919506081050745</c:v>
                </c:pt>
                <c:pt idx="201">
                  <c:v>1.8864808414247647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9514240"/>
        <c:axId val="135997312"/>
      </c:scatterChart>
      <c:valAx>
        <c:axId val="139514240"/>
        <c:scaling>
          <c:orientation val="minMax"/>
          <c:max val="7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itchFamily="18" charset="0"/>
                    <a:ea typeface="+mn-ea"/>
                    <a:cs typeface="Times New Roman" pitchFamily="18" charset="0"/>
                  </a:defRPr>
                </a:pPr>
                <a:r>
                  <a:rPr lang="en-US" sz="1200" b="1">
                    <a:solidFill>
                      <a:sysClr val="windowText" lastClr="000000"/>
                    </a:solidFill>
                    <a:latin typeface="Times New Roman" pitchFamily="18" charset="0"/>
                    <a:cs typeface="Times New Roman" pitchFamily="18" charset="0"/>
                  </a:rPr>
                  <a:t>Time (h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itchFamily="18" charset="0"/>
                <a:ea typeface="+mn-ea"/>
                <a:cs typeface="Times New Roman" pitchFamily="18" charset="0"/>
              </a:defRPr>
            </a:pPr>
            <a:endParaRPr lang="nb-NO"/>
          </a:p>
        </c:txPr>
        <c:crossAx val="135997312"/>
        <c:crossesAt val="0"/>
        <c:crossBetween val="midCat"/>
        <c:majorUnit val="10"/>
      </c:valAx>
      <c:valAx>
        <c:axId val="135997312"/>
        <c:scaling>
          <c:orientation val="minMax"/>
          <c:max val="3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Times New Roman" pitchFamily="18" charset="0"/>
                    <a:ea typeface="+mn-ea"/>
                    <a:cs typeface="Times New Roman" pitchFamily="18" charset="0"/>
                  </a:defRPr>
                </a:pPr>
                <a:r>
                  <a:rPr lang="en-US" sz="1200" b="1" dirty="0">
                    <a:solidFill>
                      <a:sysClr val="windowText" lastClr="000000"/>
                    </a:solidFill>
                    <a:latin typeface="Times New Roman" pitchFamily="18" charset="0"/>
                    <a:cs typeface="Times New Roman" pitchFamily="18" charset="0"/>
                  </a:rPr>
                  <a:t>Growth (</a:t>
                </a:r>
                <a:r>
                  <a:rPr lang="en-US" sz="1200" b="1" dirty="0" smtClean="0">
                    <a:solidFill>
                      <a:sysClr val="windowText" lastClr="000000"/>
                    </a:solidFill>
                    <a:latin typeface="Times New Roman" pitchFamily="18" charset="0"/>
                    <a:cs typeface="Times New Roman" pitchFamily="18" charset="0"/>
                  </a:rPr>
                  <a:t>OD</a:t>
                </a:r>
                <a:r>
                  <a:rPr lang="en-US" sz="1200" b="1" baseline="-25000" dirty="0" smtClean="0">
                    <a:solidFill>
                      <a:sysClr val="windowText" lastClr="000000"/>
                    </a:solidFill>
                    <a:latin typeface="Times New Roman" pitchFamily="18" charset="0"/>
                    <a:cs typeface="Times New Roman" pitchFamily="18" charset="0"/>
                  </a:rPr>
                  <a:t>600</a:t>
                </a:r>
                <a:r>
                  <a:rPr lang="en-US" sz="1200" b="1" dirty="0" smtClean="0">
                    <a:solidFill>
                      <a:sysClr val="windowText" lastClr="000000"/>
                    </a:solidFill>
                    <a:latin typeface="Times New Roman" pitchFamily="18" charset="0"/>
                    <a:cs typeface="Times New Roman" pitchFamily="18" charset="0"/>
                  </a:rPr>
                  <a:t>)</a:t>
                </a:r>
                <a:endParaRPr lang="en-US" sz="1200" b="1" dirty="0">
                  <a:solidFill>
                    <a:sysClr val="windowText" lastClr="000000"/>
                  </a:solidFill>
                  <a:latin typeface="Times New Roman" pitchFamily="18" charset="0"/>
                  <a:cs typeface="Times New Roman" pitchFamily="18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0.0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itchFamily="18" charset="0"/>
                <a:ea typeface="+mn-ea"/>
                <a:cs typeface="Times New Roman" pitchFamily="18" charset="0"/>
              </a:defRPr>
            </a:pPr>
            <a:endParaRPr lang="nb-NO"/>
          </a:p>
        </c:txPr>
        <c:crossAx val="139514240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"/>
          <c:y val="0.86522197305636583"/>
          <c:w val="0.98640750273429734"/>
          <c:h val="0.13382935610457852"/>
        </c:manualLayout>
      </c:layout>
      <c:overlay val="0"/>
      <c:txPr>
        <a:bodyPr/>
        <a:lstStyle/>
        <a:p>
          <a:pPr>
            <a:defRPr sz="1200">
              <a:latin typeface="Times New Roman" pitchFamily="18" charset="0"/>
              <a:cs typeface="Times New Roman" pitchFamily="18" charset="0"/>
            </a:defRPr>
          </a:pPr>
          <a:endParaRPr lang="nb-NO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nb-NO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09472-F729-48CE-A7E9-32C5ECA93E60}" type="datetimeFigureOut">
              <a:rPr lang="nb-NO" smtClean="0"/>
              <a:t>02.12.2016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4CB92-B689-4AD8-92F0-CBC96B72E5C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2441717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09472-F729-48CE-A7E9-32C5ECA93E60}" type="datetimeFigureOut">
              <a:rPr lang="nb-NO" smtClean="0"/>
              <a:t>02.12.2016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4CB92-B689-4AD8-92F0-CBC96B72E5C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7530130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386387" y="396701"/>
            <a:ext cx="1671638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1475" y="396701"/>
            <a:ext cx="4900613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09472-F729-48CE-A7E9-32C5ECA93E60}" type="datetimeFigureOut">
              <a:rPr lang="nb-NO" smtClean="0"/>
              <a:t>02.12.2016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4CB92-B689-4AD8-92F0-CBC96B72E5C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2159008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09472-F729-48CE-A7E9-32C5ECA93E60}" type="datetimeFigureOut">
              <a:rPr lang="nb-NO" smtClean="0"/>
              <a:t>02.12.2016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4CB92-B689-4AD8-92F0-CBC96B72E5C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1742444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09472-F729-48CE-A7E9-32C5ECA93E60}" type="datetimeFigureOut">
              <a:rPr lang="nb-NO" smtClean="0"/>
              <a:t>02.12.2016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4CB92-B689-4AD8-92F0-CBC96B72E5C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1779611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1475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71900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09472-F729-48CE-A7E9-32C5ECA93E60}" type="datetimeFigureOut">
              <a:rPr lang="nb-NO" smtClean="0"/>
              <a:t>02.12.2016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4CB92-B689-4AD8-92F0-CBC96B72E5C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939413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09472-F729-48CE-A7E9-32C5ECA93E60}" type="datetimeFigureOut">
              <a:rPr lang="nb-NO" smtClean="0"/>
              <a:t>02.12.2016</a:t>
            </a:fld>
            <a:endParaRPr lang="nb-NO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4CB92-B689-4AD8-92F0-CBC96B72E5C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1768633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09472-F729-48CE-A7E9-32C5ECA93E60}" type="datetimeFigureOut">
              <a:rPr lang="nb-NO" smtClean="0"/>
              <a:t>02.12.2016</a:t>
            </a:fld>
            <a:endParaRPr lang="nb-NO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4CB92-B689-4AD8-92F0-CBC96B72E5C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5626503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09472-F729-48CE-A7E9-32C5ECA93E60}" type="datetimeFigureOut">
              <a:rPr lang="nb-NO" smtClean="0"/>
              <a:t>02.12.2016</a:t>
            </a:fld>
            <a:endParaRPr lang="nb-NO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4CB92-B689-4AD8-92F0-CBC96B72E5C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9159630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09472-F729-48CE-A7E9-32C5ECA93E60}" type="datetimeFigureOut">
              <a:rPr lang="nb-NO" smtClean="0"/>
              <a:t>02.12.2016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4CB92-B689-4AD8-92F0-CBC96B72E5C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5176353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09472-F729-48CE-A7E9-32C5ECA93E60}" type="datetimeFigureOut">
              <a:rPr lang="nb-NO" smtClean="0"/>
              <a:t>02.12.2016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4CB92-B689-4AD8-92F0-CBC96B72E5C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2651669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F09472-F729-48CE-A7E9-32C5ECA93E60}" type="datetimeFigureOut">
              <a:rPr lang="nb-NO" smtClean="0"/>
              <a:t>02.12.2016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A4CB92-B689-4AD8-92F0-CBC96B72E5C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9714933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116632" y="128464"/>
            <a:ext cx="2204864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b-NO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upplementary</a:t>
            </a:r>
            <a:r>
              <a:rPr kumimoji="0" lang="nb-NO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nb-NO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igure</a:t>
            </a:r>
            <a:r>
              <a:rPr kumimoji="0" lang="nb-NO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1:</a:t>
            </a:r>
            <a:endParaRPr kumimoji="0" lang="nb-NO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nb-NO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5" name="Char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01681622"/>
              </p:ext>
            </p:extLst>
          </p:nvPr>
        </p:nvGraphicFramePr>
        <p:xfrm>
          <a:off x="1025741" y="1424608"/>
          <a:ext cx="4607560" cy="47447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Rectangle 3"/>
          <p:cNvSpPr>
            <a:spLocks noChangeArrowheads="1"/>
          </p:cNvSpPr>
          <p:nvPr/>
        </p:nvSpPr>
        <p:spPr bwMode="auto">
          <a:xfrm>
            <a:off x="908720" y="6681192"/>
            <a:ext cx="184731" cy="3231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b-NO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/>
            </a:r>
            <a:br>
              <a:rPr kumimoji="0" lang="nb-NO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</a:br>
            <a:endParaRPr kumimoji="0" lang="nb-NO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48680" y="6393159"/>
            <a:ext cx="602032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igure S1: Growth profiles of </a:t>
            </a:r>
            <a:r>
              <a:rPr kumimoji="0" lang="en-GB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Pseudomonas fluorescence</a:t>
            </a: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SBW25 and MS2. </a:t>
            </a:r>
            <a:endParaRPr kumimoji="0" lang="nb-NO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The strains were cultivated in 0.5 x PIA in </a:t>
            </a:r>
            <a:r>
              <a:rPr kumimoji="0" lang="en-GB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Biolector</a:t>
            </a:r>
            <a:r>
              <a:rPr lang="en-GB" sz="1200" b="1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®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GB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microreactors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. For conditions, see Materials and methods. Each curve is based on 4 cultivations of each strain/condition, standard deviation is indicated by error bars. </a:t>
            </a:r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34469916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9</TotalTime>
  <Words>64</Words>
  <Application>Microsoft Office PowerPoint</Application>
  <PresentationFormat>A4 Paper (210x297 mm)</PresentationFormat>
  <Paragraphs>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NTNU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lga Ertesvåg</dc:creator>
  <cp:lastModifiedBy>Helga Ertesvåg</cp:lastModifiedBy>
  <cp:revision>4</cp:revision>
  <dcterms:created xsi:type="dcterms:W3CDTF">2016-12-02T08:18:01Z</dcterms:created>
  <dcterms:modified xsi:type="dcterms:W3CDTF">2016-12-02T09:47:45Z</dcterms:modified>
</cp:coreProperties>
</file>